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59" r:id="rId4"/>
    <p:sldId id="261" r:id="rId5"/>
  </p:sldIdLst>
  <p:sldSz cx="7559675" cy="1069181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20044"/>
    <a:srgbClr val="000043"/>
    <a:srgbClr val="EDFBF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628" autoAdjust="0"/>
    <p:restoredTop sz="94660"/>
  </p:normalViewPr>
  <p:slideViewPr>
    <p:cSldViewPr snapToGrid="0">
      <p:cViewPr varScale="1">
        <p:scale>
          <a:sx n="45" d="100"/>
          <a:sy n="45" d="100"/>
        </p:scale>
        <p:origin x="2574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0303301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7884863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779407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007938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887909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065163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625777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569979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550232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28065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 smtClean="0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23962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Formatvorlagen des Textmasters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7B11D0-D325-4747-A3B5-3F6FFC100313}" type="datetimeFigureOut">
              <a:rPr lang="de-DE" smtClean="0"/>
              <a:t>12.04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80C5C5-B83D-4BFF-A1D2-405785DBE2D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703720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21" Type="http://schemas.openxmlformats.org/officeDocument/2006/relationships/image" Target="../media/image20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6.png"/><Relationship Id="rId18" Type="http://schemas.openxmlformats.org/officeDocument/2006/relationships/image" Target="../media/image8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5.png"/><Relationship Id="rId17" Type="http://schemas.openxmlformats.org/officeDocument/2006/relationships/image" Target="../media/image19.png"/><Relationship Id="rId2" Type="http://schemas.openxmlformats.org/officeDocument/2006/relationships/image" Target="../media/image1.png"/><Relationship Id="rId16" Type="http://schemas.openxmlformats.org/officeDocument/2006/relationships/image" Target="../media/image20.png"/><Relationship Id="rId20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4.png"/><Relationship Id="rId5" Type="http://schemas.openxmlformats.org/officeDocument/2006/relationships/image" Target="../media/image4.png"/><Relationship Id="rId15" Type="http://schemas.openxmlformats.org/officeDocument/2006/relationships/image" Target="../media/image9.png"/><Relationship Id="rId10" Type="http://schemas.openxmlformats.org/officeDocument/2006/relationships/image" Target="../media/image13.png"/><Relationship Id="rId19" Type="http://schemas.openxmlformats.org/officeDocument/2006/relationships/image" Target="../media/image7.jpeg"/><Relationship Id="rId4" Type="http://schemas.openxmlformats.org/officeDocument/2006/relationships/image" Target="../media/image3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openxmlformats.org/officeDocument/2006/relationships/image" Target="../media/image16.png"/><Relationship Id="rId18" Type="http://schemas.openxmlformats.org/officeDocument/2006/relationships/image" Target="../media/image20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5.png"/><Relationship Id="rId17" Type="http://schemas.openxmlformats.org/officeDocument/2006/relationships/image" Target="../media/image19.png"/><Relationship Id="rId2" Type="http://schemas.openxmlformats.org/officeDocument/2006/relationships/image" Target="../media/image1.png"/><Relationship Id="rId16" Type="http://schemas.openxmlformats.org/officeDocument/2006/relationships/image" Target="../media/image9.png"/><Relationship Id="rId20" Type="http://schemas.openxmlformats.org/officeDocument/2006/relationships/image" Target="../media/image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4.png"/><Relationship Id="rId5" Type="http://schemas.openxmlformats.org/officeDocument/2006/relationships/image" Target="../media/image4.png"/><Relationship Id="rId15" Type="http://schemas.openxmlformats.org/officeDocument/2006/relationships/image" Target="../media/image18.png"/><Relationship Id="rId10" Type="http://schemas.openxmlformats.org/officeDocument/2006/relationships/image" Target="../media/image13.png"/><Relationship Id="rId19" Type="http://schemas.openxmlformats.org/officeDocument/2006/relationships/image" Target="../media/image8.png"/><Relationship Id="rId4" Type="http://schemas.openxmlformats.org/officeDocument/2006/relationships/image" Target="../media/image3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13" Type="http://schemas.openxmlformats.org/officeDocument/2006/relationships/image" Target="../media/image17.png"/><Relationship Id="rId18" Type="http://schemas.openxmlformats.org/officeDocument/2006/relationships/image" Target="../media/image8.png"/><Relationship Id="rId3" Type="http://schemas.openxmlformats.org/officeDocument/2006/relationships/image" Target="../media/image2.png"/><Relationship Id="rId7" Type="http://schemas.openxmlformats.org/officeDocument/2006/relationships/image" Target="../media/image10.png"/><Relationship Id="rId12" Type="http://schemas.openxmlformats.org/officeDocument/2006/relationships/image" Target="../media/image16.png"/><Relationship Id="rId17" Type="http://schemas.openxmlformats.org/officeDocument/2006/relationships/image" Target="../media/image20.png"/><Relationship Id="rId2" Type="http://schemas.openxmlformats.org/officeDocument/2006/relationships/image" Target="../media/image1.png"/><Relationship Id="rId16" Type="http://schemas.openxmlformats.org/officeDocument/2006/relationships/image" Target="../media/image19.png"/><Relationship Id="rId20" Type="http://schemas.openxmlformats.org/officeDocument/2006/relationships/image" Target="../media/image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5.png"/><Relationship Id="rId5" Type="http://schemas.openxmlformats.org/officeDocument/2006/relationships/image" Target="../media/image4.png"/><Relationship Id="rId15" Type="http://schemas.openxmlformats.org/officeDocument/2006/relationships/image" Target="../media/image9.png"/><Relationship Id="rId10" Type="http://schemas.openxmlformats.org/officeDocument/2006/relationships/image" Target="../media/image14.png"/><Relationship Id="rId19" Type="http://schemas.openxmlformats.org/officeDocument/2006/relationships/image" Target="../media/image7.jpeg"/><Relationship Id="rId4" Type="http://schemas.openxmlformats.org/officeDocument/2006/relationships/image" Target="../media/image3.png"/><Relationship Id="rId9" Type="http://schemas.openxmlformats.org/officeDocument/2006/relationships/image" Target="../media/image13.png"/><Relationship Id="rId14" Type="http://schemas.openxmlformats.org/officeDocument/2006/relationships/image" Target="../media/image1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5725" y="1755327"/>
            <a:ext cx="4428000" cy="270183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5725" y="4846959"/>
            <a:ext cx="4428000" cy="2701832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5725" y="7941638"/>
            <a:ext cx="4428000" cy="2701832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b="91310"/>
          <a:stretch/>
        </p:blipFill>
        <p:spPr>
          <a:xfrm>
            <a:off x="1347635" y="2048250"/>
            <a:ext cx="3324179" cy="196209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>
          <a:xfrm>
            <a:off x="1588696" y="2330597"/>
            <a:ext cx="2842056" cy="856030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829" noProof="1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9176" y="2649614"/>
            <a:ext cx="1921095" cy="217995"/>
          </a:xfrm>
          <a:prstGeom prst="rect">
            <a:avLst/>
          </a:prstGeom>
        </p:spPr>
      </p:pic>
      <p:sp>
        <p:nvSpPr>
          <p:cNvPr id="11" name="Rechteck 10"/>
          <p:cNvSpPr/>
          <p:nvPr/>
        </p:nvSpPr>
        <p:spPr>
          <a:xfrm>
            <a:off x="1887624" y="2531757"/>
            <a:ext cx="2172426" cy="65401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9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What did your answers reveal? </a:t>
            </a:r>
          </a:p>
          <a:p>
            <a:endParaRPr lang="de-DE" sz="1914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887624" y="2377299"/>
            <a:ext cx="2603157" cy="3737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You have indicated that you have felt affected by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low spirits</a:t>
            </a:r>
            <a:r>
              <a:rPr lang="de-DE" sz="400" noProof="1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,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sleep disturbances, </a:t>
            </a:r>
            <a:r>
              <a:rPr lang="de-DE" sz="400" noProof="1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and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 loss of energy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during the past two weeks. According to our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evaluation*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these are  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049176" y="2649072"/>
            <a:ext cx="60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no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596911" y="2652165"/>
            <a:ext cx="753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moderate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350762" y="2652165"/>
            <a:ext cx="674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    significant 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887624" y="2867067"/>
            <a:ext cx="2082647" cy="215444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These symptoms are most likely indications of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</a:rPr>
              <a:t>depression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. Please note that this feedback does not take the place of a thorough medical diagnosis.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887624" y="3054371"/>
            <a:ext cx="681597" cy="1384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300" noProof="1" smtClean="0">
                <a:solidFill>
                  <a:srgbClr val="020044"/>
                </a:solidFill>
              </a:rPr>
              <a:t>*The evaluation is based on the</a:t>
            </a:r>
            <a:endParaRPr lang="de-DE" sz="300" noProof="1">
              <a:solidFill>
                <a:srgbClr val="020044"/>
              </a:solidFill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/>
          <a:srcRect l="815" t="-1" b="3317"/>
          <a:stretch/>
        </p:blipFill>
        <p:spPr>
          <a:xfrm>
            <a:off x="2472375" y="3085305"/>
            <a:ext cx="434754" cy="81369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96328" y="2642286"/>
            <a:ext cx="594844" cy="232649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334453" y="235472"/>
            <a:ext cx="646801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611505" algn="just">
              <a:spcAft>
                <a:spcPts val="1200"/>
              </a:spcAft>
            </a:pPr>
            <a:r>
              <a:rPr lang="en-US" sz="1400" b="1" noProof="1" smtClean="0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Multimedia Appendix 4</a:t>
            </a:r>
            <a:r>
              <a:rPr lang="en-US" sz="1400" noProof="1" smtClean="0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. Exemplary tailored feedback for participants who indicate that their symptoms are indications of depression and that they worry about them (English translation)</a:t>
            </a:r>
            <a:r>
              <a:rPr lang="en-US" sz="1400" noProof="1" smtClean="0">
                <a:solidFill>
                  <a:srgbClr val="333333"/>
                </a:solidFill>
                <a:latin typeface="+mj-lt"/>
                <a:ea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en-US" sz="1400" noProof="1">
              <a:solidFill>
                <a:srgbClr val="333333"/>
              </a:solidFill>
              <a:latin typeface="+mj-lt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8" name="Grafik 6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617756" y="3311549"/>
            <a:ext cx="2772000" cy="386175"/>
          </a:xfrm>
          <a:prstGeom prst="rect">
            <a:avLst/>
          </a:prstGeom>
        </p:spPr>
      </p:pic>
      <p:sp>
        <p:nvSpPr>
          <p:cNvPr id="69" name="Textfeld 68"/>
          <p:cNvSpPr txBox="1"/>
          <p:nvPr/>
        </p:nvSpPr>
        <p:spPr>
          <a:xfrm>
            <a:off x="1642141" y="3326724"/>
            <a:ext cx="1355960" cy="246478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Do you think your symptoms are </a:t>
            </a:r>
            <a:r>
              <a:rPr lang="en-GB" sz="501" b="1" dirty="0">
                <a:solidFill>
                  <a:srgbClr val="020044"/>
                </a:solidFill>
                <a:latin typeface="Constantia" panose="02030602050306030303" pitchFamily="18" charset="0"/>
              </a:rPr>
              <a:t>indications </a:t>
            </a:r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of depression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033158" y="3332095"/>
            <a:ext cx="1394813" cy="169405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Are you worried about your symptoms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1926809" y="3540431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2180840" y="3540532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2437306" y="3540407"/>
            <a:ext cx="334322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maybe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3446973" y="3539335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700842" y="3538052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4384425" y="3318403"/>
            <a:ext cx="4571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77" name="Textfeld 76"/>
          <p:cNvSpPr txBox="1"/>
          <p:nvPr/>
        </p:nvSpPr>
        <p:spPr>
          <a:xfrm>
            <a:off x="1560161" y="5575451"/>
            <a:ext cx="156193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400" dirty="0" smtClean="0">
                <a:solidFill>
                  <a:srgbClr val="000043"/>
                </a:solidFill>
              </a:rPr>
              <a:t>Your symptoms are common – seeking advice helps. It is best to make an </a:t>
            </a:r>
            <a:r>
              <a:rPr lang="en-GB" sz="400" b="1" dirty="0" smtClean="0">
                <a:solidFill>
                  <a:srgbClr val="52C4B1"/>
                </a:solidFill>
              </a:rPr>
              <a:t>appointment with your general practitioner </a:t>
            </a:r>
            <a:r>
              <a:rPr lang="en-GB" sz="400" dirty="0" smtClean="0">
                <a:solidFill>
                  <a:srgbClr val="000043"/>
                </a:solidFill>
              </a:rPr>
              <a:t>to talk about your evaluation. You can print it out and take it with you to start the conversation.</a:t>
            </a:r>
            <a:endParaRPr lang="en-GB" sz="400" dirty="0">
              <a:solidFill>
                <a:srgbClr val="000043"/>
              </a:solidFill>
            </a:endParaRPr>
          </a:p>
        </p:txBody>
      </p:sp>
      <p:sp>
        <p:nvSpPr>
          <p:cNvPr id="78" name="Textfeld 77"/>
          <p:cNvSpPr txBox="1"/>
          <p:nvPr/>
        </p:nvSpPr>
        <p:spPr>
          <a:xfrm>
            <a:off x="1560162" y="5422394"/>
            <a:ext cx="171579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And now – what should I do firs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pic>
        <p:nvPicPr>
          <p:cNvPr id="84" name="Grafik 8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50762" y="5270611"/>
            <a:ext cx="866068" cy="866068"/>
          </a:xfrm>
          <a:prstGeom prst="rect">
            <a:avLst/>
          </a:prstGeom>
        </p:spPr>
      </p:pic>
      <p:pic>
        <p:nvPicPr>
          <p:cNvPr id="85" name="Grafik 84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644715" y="5916810"/>
            <a:ext cx="122036" cy="113761"/>
          </a:xfrm>
          <a:prstGeom prst="rect">
            <a:avLst/>
          </a:prstGeom>
        </p:spPr>
      </p:pic>
      <p:sp>
        <p:nvSpPr>
          <p:cNvPr id="86" name="Textfeld 85"/>
          <p:cNvSpPr txBox="1"/>
          <p:nvPr/>
        </p:nvSpPr>
        <p:spPr>
          <a:xfrm>
            <a:off x="1686419" y="5914173"/>
            <a:ext cx="490333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Print your feedback </a:t>
            </a:r>
            <a:endParaRPr lang="en-GB" sz="300" u="sng" dirty="0"/>
          </a:p>
        </p:txBody>
      </p:sp>
      <p:pic>
        <p:nvPicPr>
          <p:cNvPr id="87" name="Grafik 86"/>
          <p:cNvPicPr>
            <a:picLocks noChangeAspect="1"/>
          </p:cNvPicPr>
          <p:nvPr/>
        </p:nvPicPr>
        <p:blipFill rotWithShape="1">
          <a:blip r:embed="rId10"/>
          <a:srcRect b="15014"/>
          <a:stretch/>
        </p:blipFill>
        <p:spPr>
          <a:xfrm>
            <a:off x="2086775" y="5914174"/>
            <a:ext cx="154984" cy="116399"/>
          </a:xfrm>
          <a:prstGeom prst="rect">
            <a:avLst/>
          </a:prstGeom>
        </p:spPr>
      </p:pic>
      <p:sp>
        <p:nvSpPr>
          <p:cNvPr id="88" name="Textfeld 87"/>
          <p:cNvSpPr txBox="1"/>
          <p:nvPr/>
        </p:nvSpPr>
        <p:spPr>
          <a:xfrm>
            <a:off x="2164267" y="5914690"/>
            <a:ext cx="545309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Make an appointment</a:t>
            </a:r>
            <a:endParaRPr lang="en-GB" sz="300" u="sng" dirty="0"/>
          </a:p>
        </p:txBody>
      </p:sp>
      <p:pic>
        <p:nvPicPr>
          <p:cNvPr id="105" name="Grafik 104"/>
          <p:cNvPicPr>
            <a:picLocks noChangeAspect="1"/>
          </p:cNvPicPr>
          <p:nvPr/>
        </p:nvPicPr>
        <p:blipFill rotWithShape="1">
          <a:blip r:embed="rId11"/>
          <a:srcRect b="54466"/>
          <a:stretch/>
        </p:blipFill>
        <p:spPr>
          <a:xfrm>
            <a:off x="1382586" y="8294658"/>
            <a:ext cx="3231029" cy="877751"/>
          </a:xfrm>
          <a:prstGeom prst="rect">
            <a:avLst/>
          </a:prstGeom>
        </p:spPr>
      </p:pic>
      <p:sp>
        <p:nvSpPr>
          <p:cNvPr id="89" name="Textfeld 88"/>
          <p:cNvSpPr txBox="1"/>
          <p:nvPr/>
        </p:nvSpPr>
        <p:spPr>
          <a:xfrm>
            <a:off x="2444262" y="6257989"/>
            <a:ext cx="191261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         Depression – how to treat i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2638240" y="6423487"/>
            <a:ext cx="1561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400" noProof="1">
                <a:solidFill>
                  <a:srgbClr val="020044"/>
                </a:solidFill>
              </a:rPr>
              <a:t>There are very good treatments for </a:t>
            </a:r>
            <a:r>
              <a:rPr lang="de-DE" sz="400" noProof="1" smtClean="0">
                <a:solidFill>
                  <a:srgbClr val="020044"/>
                </a:solidFill>
              </a:rPr>
              <a:t>depression</a:t>
            </a:r>
            <a:r>
              <a:rPr lang="en-GB" sz="400" dirty="0" smtClean="0">
                <a:solidFill>
                  <a:srgbClr val="000043"/>
                </a:solidFill>
              </a:rPr>
              <a:t> – especially when it occurs for the first time. </a:t>
            </a:r>
            <a:r>
              <a:rPr lang="en-GB" sz="400" b="1" dirty="0" smtClean="0">
                <a:solidFill>
                  <a:srgbClr val="52C4B1"/>
                </a:solidFill>
              </a:rPr>
              <a:t>Psychotherapy</a:t>
            </a:r>
            <a:r>
              <a:rPr lang="en-GB" sz="400" dirty="0" smtClean="0">
                <a:solidFill>
                  <a:srgbClr val="000043"/>
                </a:solidFill>
              </a:rPr>
              <a:t> or medication are most effective. </a:t>
            </a:r>
            <a:r>
              <a:rPr lang="en-GB" sz="400" b="1" dirty="0" smtClean="0">
                <a:solidFill>
                  <a:srgbClr val="52C4B1"/>
                </a:solidFill>
              </a:rPr>
              <a:t>Online therapies </a:t>
            </a:r>
            <a:r>
              <a:rPr lang="en-GB" sz="400" dirty="0" smtClean="0">
                <a:solidFill>
                  <a:srgbClr val="000043"/>
                </a:solidFill>
              </a:rPr>
              <a:t>are also readily available. Together with your health professional you can decide which treatment is best for you.</a:t>
            </a:r>
            <a:endParaRPr lang="en-GB" sz="400" dirty="0">
              <a:solidFill>
                <a:srgbClr val="000043"/>
              </a:solidFill>
            </a:endParaRPr>
          </a:p>
        </p:txBody>
      </p:sp>
      <p:pic>
        <p:nvPicPr>
          <p:cNvPr id="93" name="Grafik 9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622262" y="6226955"/>
            <a:ext cx="822000" cy="822000"/>
          </a:xfrm>
          <a:prstGeom prst="rect">
            <a:avLst/>
          </a:prstGeom>
        </p:spPr>
      </p:pic>
      <p:pic>
        <p:nvPicPr>
          <p:cNvPr id="99" name="Grafik 9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970392" y="8440419"/>
            <a:ext cx="2217432" cy="203844"/>
          </a:xfrm>
          <a:prstGeom prst="rect">
            <a:avLst/>
          </a:prstGeom>
        </p:spPr>
      </p:pic>
      <p:pic>
        <p:nvPicPr>
          <p:cNvPr id="100" name="Grafik 9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771329" y="8880221"/>
            <a:ext cx="542472" cy="109812"/>
          </a:xfrm>
          <a:prstGeom prst="rect">
            <a:avLst/>
          </a:prstGeom>
        </p:spPr>
      </p:pic>
      <p:pic>
        <p:nvPicPr>
          <p:cNvPr id="101" name="Grafik 100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449244" y="8982445"/>
            <a:ext cx="589398" cy="112053"/>
          </a:xfrm>
          <a:prstGeom prst="rect">
            <a:avLst/>
          </a:prstGeom>
        </p:spPr>
      </p:pic>
      <p:pic>
        <p:nvPicPr>
          <p:cNvPr id="102" name="Grafik 10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137329" y="8982445"/>
            <a:ext cx="486260" cy="105252"/>
          </a:xfrm>
          <a:prstGeom prst="rect">
            <a:avLst/>
          </a:prstGeom>
        </p:spPr>
      </p:pic>
      <p:pic>
        <p:nvPicPr>
          <p:cNvPr id="103" name="Grafik 102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736289" y="8880221"/>
            <a:ext cx="533021" cy="162283"/>
          </a:xfrm>
          <a:prstGeom prst="rect">
            <a:avLst/>
          </a:prstGeom>
        </p:spPr>
      </p:pic>
      <p:pic>
        <p:nvPicPr>
          <p:cNvPr id="110" name="Grafik 109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047141" y="8750226"/>
            <a:ext cx="556437" cy="556437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12" name="Grafik 111"/>
          <p:cNvPicPr>
            <a:picLocks noChangeAspect="1"/>
          </p:cNvPicPr>
          <p:nvPr/>
        </p:nvPicPr>
        <p:blipFill rotWithShape="1">
          <a:blip r:embed="rId19"/>
          <a:srcRect t="1" b="11580"/>
          <a:stretch/>
        </p:blipFill>
        <p:spPr>
          <a:xfrm>
            <a:off x="2358070" y="8292144"/>
            <a:ext cx="1282543" cy="105645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113" name="Textfeld 112"/>
          <p:cNvSpPr txBox="1"/>
          <p:nvPr/>
        </p:nvSpPr>
        <p:spPr>
          <a:xfrm>
            <a:off x="2357438" y="8310649"/>
            <a:ext cx="1201127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b="1" noProof="1" smtClean="0">
                <a:solidFill>
                  <a:srgbClr val="000043"/>
                </a:solidFill>
                <a:latin typeface="Constantia" panose="02030602050306030303" pitchFamily="18" charset="0"/>
              </a:rPr>
              <a:t>How do I find an online therapy?</a:t>
            </a:r>
            <a:endParaRPr lang="de-DE" sz="500" b="1" noProof="1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2357438" y="8431057"/>
            <a:ext cx="126615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With a prescription from a doctor, the following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 </a:t>
            </a:r>
            <a:r>
              <a:rPr lang="de-DE" sz="400" noProof="1" smtClean="0">
                <a:solidFill>
                  <a:srgbClr val="000043"/>
                </a:solidFill>
              </a:rPr>
              <a:t>are fully covered by your public health insurance company </a:t>
            </a:r>
            <a:r>
              <a:rPr lang="de-DE" sz="400" b="1" noProof="1" smtClean="0">
                <a:solidFill>
                  <a:srgbClr val="40C5B1"/>
                </a:solidFill>
              </a:rPr>
              <a:t>ABC</a:t>
            </a:r>
            <a:r>
              <a:rPr lang="de-DE" sz="400" noProof="1" smtClean="0">
                <a:solidFill>
                  <a:srgbClr val="000043"/>
                </a:solidFill>
              </a:rPr>
              <a:t>:</a:t>
            </a:r>
            <a:endParaRPr lang="de-DE" sz="400" noProof="1">
              <a:solidFill>
                <a:srgbClr val="000043"/>
              </a:solidFill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2509338" y="8781550"/>
            <a:ext cx="1007372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Deprexis online therapy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2508576" y="8683821"/>
            <a:ext cx="872679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Selfapy-Course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2491147" y="9063586"/>
            <a:ext cx="87267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MindDoc (Schön-Klinik)</a:t>
            </a:r>
          </a:p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HelloBette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2376732" y="8888937"/>
            <a:ext cx="122684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Some health insurance companies also cover the cost of other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</a:t>
            </a:r>
            <a:r>
              <a:rPr lang="de-DE" sz="400" noProof="1" smtClean="0">
                <a:solidFill>
                  <a:srgbClr val="000043"/>
                </a:solidFill>
              </a:rPr>
              <a:t>, such as:</a:t>
            </a:r>
            <a:endParaRPr lang="de-DE" sz="400" noProof="1">
              <a:solidFill>
                <a:srgbClr val="000043"/>
              </a:solidFill>
            </a:endParaRPr>
          </a:p>
        </p:txBody>
      </p:sp>
      <p:pic>
        <p:nvPicPr>
          <p:cNvPr id="119" name="Grafik 118"/>
          <p:cNvPicPr>
            <a:picLocks noChangeAspect="1"/>
          </p:cNvPicPr>
          <p:nvPr/>
        </p:nvPicPr>
        <p:blipFill rotWithShape="1">
          <a:blip r:embed="rId10"/>
          <a:srcRect b="15014"/>
          <a:stretch/>
        </p:blipFill>
        <p:spPr>
          <a:xfrm>
            <a:off x="2395741" y="8817749"/>
            <a:ext cx="112221" cy="84283"/>
          </a:xfrm>
          <a:prstGeom prst="rect">
            <a:avLst/>
          </a:prstGeom>
        </p:spPr>
      </p:pic>
      <p:cxnSp>
        <p:nvCxnSpPr>
          <p:cNvPr id="131" name="Gerade Verbindung mit Pfeil 130"/>
          <p:cNvCxnSpPr/>
          <p:nvPr/>
        </p:nvCxnSpPr>
        <p:spPr>
          <a:xfrm flipH="1">
            <a:off x="3822351" y="2331544"/>
            <a:ext cx="1509668" cy="157215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>
            <a:off x="5332019" y="2085973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profile</a:t>
            </a:r>
            <a:endParaRPr lang="en-US" sz="1200" dirty="0"/>
          </a:p>
        </p:txBody>
      </p:sp>
      <p:sp>
        <p:nvSpPr>
          <p:cNvPr id="137" name="Textfeld 136"/>
          <p:cNvSpPr txBox="1"/>
          <p:nvPr/>
        </p:nvSpPr>
        <p:spPr>
          <a:xfrm>
            <a:off x="5332019" y="5101293"/>
            <a:ext cx="1382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pecialist preferences</a:t>
            </a:r>
          </a:p>
        </p:txBody>
      </p:sp>
      <p:cxnSp>
        <p:nvCxnSpPr>
          <p:cNvPr id="138" name="Gerade Verbindung mit Pfeil 137"/>
          <p:cNvCxnSpPr/>
          <p:nvPr/>
        </p:nvCxnSpPr>
        <p:spPr>
          <a:xfrm flipH="1">
            <a:off x="2889857" y="5422394"/>
            <a:ext cx="2442162" cy="285540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1" name="Textfeld 140"/>
          <p:cNvSpPr txBox="1"/>
          <p:nvPr/>
        </p:nvSpPr>
        <p:spPr>
          <a:xfrm>
            <a:off x="1559018" y="9379281"/>
            <a:ext cx="2009443" cy="200055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7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A brief explanation - what is depression?</a:t>
            </a:r>
            <a:endParaRPr lang="de-DE" sz="700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142" name="Textfeld 141"/>
          <p:cNvSpPr txBox="1"/>
          <p:nvPr/>
        </p:nvSpPr>
        <p:spPr>
          <a:xfrm>
            <a:off x="1554675" y="9524782"/>
            <a:ext cx="2004186" cy="153888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Depression is often underestimated at first as it can look different for everyone:</a:t>
            </a:r>
            <a:endParaRPr lang="de-DE" sz="400" noProof="1">
              <a:solidFill>
                <a:srgbClr val="020044"/>
              </a:solidFill>
            </a:endParaRPr>
          </a:p>
        </p:txBody>
      </p:sp>
      <p:sp>
        <p:nvSpPr>
          <p:cNvPr id="143" name="Textfeld 142"/>
          <p:cNvSpPr txBox="1"/>
          <p:nvPr/>
        </p:nvSpPr>
        <p:spPr>
          <a:xfrm>
            <a:off x="1557609" y="9634731"/>
            <a:ext cx="1941903" cy="400110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 smtClean="0">
                <a:solidFill>
                  <a:srgbClr val="020044"/>
                </a:solidFill>
              </a:rPr>
              <a:t>typical symptoms are </a:t>
            </a:r>
            <a:r>
              <a:rPr lang="de-DE" sz="400" b="1" noProof="1">
                <a:solidFill>
                  <a:srgbClr val="4FC3B0"/>
                </a:solidFill>
              </a:rPr>
              <a:t>a </a:t>
            </a:r>
            <a:r>
              <a:rPr lang="de-DE" sz="400" b="1" noProof="1" smtClean="0">
                <a:solidFill>
                  <a:srgbClr val="4FC3B0"/>
                </a:solidFill>
              </a:rPr>
              <a:t>lack of energy, low spirits </a:t>
            </a:r>
            <a:r>
              <a:rPr lang="de-DE" sz="400" noProof="1" smtClean="0">
                <a:solidFill>
                  <a:srgbClr val="020044"/>
                </a:solidFill>
              </a:rPr>
              <a:t>and </a:t>
            </a:r>
            <a:r>
              <a:rPr lang="de-DE" sz="400" b="1" noProof="1" smtClean="0">
                <a:solidFill>
                  <a:srgbClr val="4FC3B0"/>
                </a:solidFill>
              </a:rPr>
              <a:t>physical symptom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 smtClean="0">
                <a:solidFill>
                  <a:srgbClr val="020044"/>
                </a:solidFill>
              </a:rPr>
              <a:t>triggers are for example </a:t>
            </a:r>
            <a:r>
              <a:rPr lang="de-DE" sz="400" b="1" noProof="1" smtClean="0">
                <a:solidFill>
                  <a:srgbClr val="4FC3B0"/>
                </a:solidFill>
              </a:rPr>
              <a:t>stress, problems from the past </a:t>
            </a:r>
            <a:r>
              <a:rPr lang="de-DE" sz="400" noProof="1" smtClean="0">
                <a:solidFill>
                  <a:srgbClr val="020044"/>
                </a:solidFill>
              </a:rPr>
              <a:t>or </a:t>
            </a:r>
            <a:r>
              <a:rPr lang="de-DE" sz="400" b="1" noProof="1" smtClean="0">
                <a:solidFill>
                  <a:srgbClr val="4FC3B0"/>
                </a:solidFill>
              </a:rPr>
              <a:t>biological factors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 smtClean="0">
                <a:solidFill>
                  <a:srgbClr val="020044"/>
                </a:solidFill>
              </a:rPr>
              <a:t>the symptoms can subside on their own, but without treatment they </a:t>
            </a:r>
            <a:r>
              <a:rPr lang="de-DE" sz="400" b="1" noProof="1" smtClean="0">
                <a:solidFill>
                  <a:srgbClr val="4FC3B0"/>
                </a:solidFill>
              </a:rPr>
              <a:t>often come back</a:t>
            </a:r>
          </a:p>
          <a:p>
            <a:pPr marL="171450" indent="-171450">
              <a:buFont typeface="Arial" panose="020B0604020202020204" pitchFamily="34" charset="0"/>
              <a:buChar char="•"/>
            </a:pPr>
            <a:r>
              <a:rPr lang="de-DE" sz="400" noProof="1">
                <a:solidFill>
                  <a:srgbClr val="020044"/>
                </a:solidFill>
              </a:rPr>
              <a:t>t</a:t>
            </a:r>
            <a:r>
              <a:rPr lang="de-DE" sz="400" noProof="1" smtClean="0">
                <a:solidFill>
                  <a:srgbClr val="020044"/>
                </a:solidFill>
              </a:rPr>
              <a:t>he symptoms affect everyday life and increase the </a:t>
            </a:r>
            <a:r>
              <a:rPr lang="de-DE" sz="400" b="1" noProof="1" smtClean="0">
                <a:solidFill>
                  <a:srgbClr val="4FC3B0"/>
                </a:solidFill>
              </a:rPr>
              <a:t>risk of a physical illness</a:t>
            </a:r>
            <a:endParaRPr lang="de-DE" sz="400" b="1" noProof="1">
              <a:solidFill>
                <a:srgbClr val="4FC3B0"/>
              </a:solidFill>
            </a:endParaRPr>
          </a:p>
        </p:txBody>
      </p:sp>
      <p:sp>
        <p:nvSpPr>
          <p:cNvPr id="144" name="Textfeld 143"/>
          <p:cNvSpPr txBox="1"/>
          <p:nvPr/>
        </p:nvSpPr>
        <p:spPr>
          <a:xfrm>
            <a:off x="1617158" y="10045495"/>
            <a:ext cx="843829" cy="61555"/>
          </a:xfrm>
          <a:prstGeom prst="rect">
            <a:avLst/>
          </a:prstGeom>
          <a:solidFill>
            <a:srgbClr val="FFFFFF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More information can be found at</a:t>
            </a:r>
          </a:p>
        </p:txBody>
      </p:sp>
      <p:pic>
        <p:nvPicPr>
          <p:cNvPr id="145" name="Grafik 144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350043" y="10013532"/>
            <a:ext cx="137160" cy="104172"/>
          </a:xfrm>
          <a:prstGeom prst="rect">
            <a:avLst/>
          </a:prstGeom>
        </p:spPr>
      </p:pic>
      <p:sp>
        <p:nvSpPr>
          <p:cNvPr id="146" name="Textfeld 145"/>
          <p:cNvSpPr txBox="1"/>
          <p:nvPr/>
        </p:nvSpPr>
        <p:spPr>
          <a:xfrm>
            <a:off x="2404356" y="9985829"/>
            <a:ext cx="601861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" u="sng" noProof="1" smtClean="0">
                <a:solidFill>
                  <a:srgbClr val="292B64"/>
                </a:solidFill>
              </a:rPr>
              <a:t>www.psychenet.de</a:t>
            </a:r>
            <a:endParaRPr lang="de-DE" sz="400" u="sng" noProof="1">
              <a:solidFill>
                <a:srgbClr val="292B64"/>
              </a:solidFill>
            </a:endParaRPr>
          </a:p>
        </p:txBody>
      </p:sp>
      <p:pic>
        <p:nvPicPr>
          <p:cNvPr id="147" name="Grafik 146"/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3661032" y="9369970"/>
            <a:ext cx="781535" cy="781535"/>
          </a:xfrm>
          <a:prstGeom prst="rect">
            <a:avLst/>
          </a:prstGeom>
        </p:spPr>
      </p:pic>
      <p:cxnSp>
        <p:nvCxnSpPr>
          <p:cNvPr id="151" name="Gerader Verbinder 150"/>
          <p:cNvCxnSpPr/>
          <p:nvPr/>
        </p:nvCxnSpPr>
        <p:spPr>
          <a:xfrm>
            <a:off x="2262491" y="9736517"/>
            <a:ext cx="1099165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2" name="Gerader Verbinder 151"/>
          <p:cNvCxnSpPr/>
          <p:nvPr/>
        </p:nvCxnSpPr>
        <p:spPr>
          <a:xfrm flipV="1">
            <a:off x="2315945" y="9798456"/>
            <a:ext cx="1065310" cy="697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5" name="Textfeld 154"/>
          <p:cNvSpPr txBox="1"/>
          <p:nvPr/>
        </p:nvSpPr>
        <p:spPr>
          <a:xfrm>
            <a:off x="5332019" y="2844528"/>
            <a:ext cx="1300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questions</a:t>
            </a:r>
            <a:r>
              <a:rPr lang="en-US" dirty="0" smtClean="0"/>
              <a:t> </a:t>
            </a:r>
            <a:endParaRPr lang="en-US" dirty="0"/>
          </a:p>
        </p:txBody>
      </p:sp>
      <p:sp>
        <p:nvSpPr>
          <p:cNvPr id="156" name="Textfeld 155"/>
          <p:cNvSpPr txBox="1"/>
          <p:nvPr/>
        </p:nvSpPr>
        <p:spPr>
          <a:xfrm>
            <a:off x="2636751" y="6810670"/>
            <a:ext cx="1725522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Exercise, sleep, and relaxation techniques can also help to support the therapy - </a:t>
            </a:r>
            <a:r>
              <a:rPr lang="de-DE" sz="400" b="1" noProof="1" smtClean="0">
                <a:solidFill>
                  <a:srgbClr val="4FC3B0"/>
                </a:solidFill>
              </a:rPr>
              <a:t>health courses </a:t>
            </a:r>
            <a:r>
              <a:rPr lang="de-DE" sz="400" noProof="1">
                <a:solidFill>
                  <a:srgbClr val="020044"/>
                </a:solidFill>
              </a:rPr>
              <a:t>in this field are supported by </a:t>
            </a:r>
            <a:r>
              <a:rPr lang="de-DE" sz="400" b="1" noProof="1">
                <a:solidFill>
                  <a:srgbClr val="52C4B1"/>
                </a:solidFill>
              </a:rPr>
              <a:t>your </a:t>
            </a:r>
            <a:r>
              <a:rPr lang="de-DE" sz="400" b="1" noProof="1" smtClean="0">
                <a:solidFill>
                  <a:srgbClr val="52C4B1"/>
                </a:solidFill>
              </a:rPr>
              <a:t>ABC (health insurance provder).</a:t>
            </a:r>
            <a:endParaRPr lang="de-DE" sz="400" b="1" noProof="1">
              <a:solidFill>
                <a:srgbClr val="52C4B1"/>
              </a:solidFill>
            </a:endParaRPr>
          </a:p>
        </p:txBody>
      </p:sp>
      <p:cxnSp>
        <p:nvCxnSpPr>
          <p:cNvPr id="157" name="Gerader Verbinder 156"/>
          <p:cNvCxnSpPr/>
          <p:nvPr/>
        </p:nvCxnSpPr>
        <p:spPr>
          <a:xfrm>
            <a:off x="1843943" y="5744728"/>
            <a:ext cx="900000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9" name="Gerader Verbinder 158"/>
          <p:cNvCxnSpPr/>
          <p:nvPr/>
        </p:nvCxnSpPr>
        <p:spPr>
          <a:xfrm>
            <a:off x="3839737" y="6982673"/>
            <a:ext cx="360000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Gerade Verbindung mit Pfeil 159"/>
          <p:cNvCxnSpPr/>
          <p:nvPr/>
        </p:nvCxnSpPr>
        <p:spPr>
          <a:xfrm flipH="1">
            <a:off x="4280884" y="6925447"/>
            <a:ext cx="1051135" cy="21584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feld 162"/>
          <p:cNvSpPr txBox="1"/>
          <p:nvPr/>
        </p:nvSpPr>
        <p:spPr>
          <a:xfrm>
            <a:off x="5332019" y="6694614"/>
            <a:ext cx="1443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health insurance </a:t>
            </a:r>
            <a:r>
              <a:rPr lang="en-US" sz="1200" dirty="0" smtClean="0"/>
              <a:t>provider</a:t>
            </a:r>
            <a:endParaRPr lang="en-US" sz="1200" dirty="0"/>
          </a:p>
        </p:txBody>
      </p:sp>
      <p:cxnSp>
        <p:nvCxnSpPr>
          <p:cNvPr id="164" name="Gerade Verbindung mit Pfeil 163"/>
          <p:cNvCxnSpPr/>
          <p:nvPr/>
        </p:nvCxnSpPr>
        <p:spPr>
          <a:xfrm flipH="1">
            <a:off x="3605318" y="8522141"/>
            <a:ext cx="1684061" cy="295504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feld 166"/>
          <p:cNvSpPr txBox="1"/>
          <p:nvPr/>
        </p:nvSpPr>
        <p:spPr>
          <a:xfrm>
            <a:off x="5332019" y="8161183"/>
            <a:ext cx="16329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online therapies offered by participant’s health insurance provider</a:t>
            </a:r>
            <a:endParaRPr lang="en-US" sz="1200" dirty="0"/>
          </a:p>
        </p:txBody>
      </p:sp>
      <p:cxnSp>
        <p:nvCxnSpPr>
          <p:cNvPr id="168" name="Gerade Verbindung mit Pfeil 167"/>
          <p:cNvCxnSpPr/>
          <p:nvPr/>
        </p:nvCxnSpPr>
        <p:spPr>
          <a:xfrm flipH="1">
            <a:off x="3452327" y="9304508"/>
            <a:ext cx="1879692" cy="405445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9" name="Gerade Verbindung mit Pfeil 168"/>
          <p:cNvCxnSpPr/>
          <p:nvPr/>
        </p:nvCxnSpPr>
        <p:spPr>
          <a:xfrm flipH="1" flipV="1">
            <a:off x="3456871" y="9792146"/>
            <a:ext cx="1832508" cy="182710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3" name="Textfeld 172"/>
          <p:cNvSpPr txBox="1"/>
          <p:nvPr/>
        </p:nvSpPr>
        <p:spPr>
          <a:xfrm>
            <a:off x="5332019" y="9073675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ymptom profiles </a:t>
            </a:r>
          </a:p>
        </p:txBody>
      </p:sp>
      <p:sp>
        <p:nvSpPr>
          <p:cNvPr id="175" name="Textfeld 174"/>
          <p:cNvSpPr txBox="1"/>
          <p:nvPr/>
        </p:nvSpPr>
        <p:spPr>
          <a:xfrm>
            <a:off x="5324211" y="9692620"/>
            <a:ext cx="15531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</a:t>
            </a:r>
            <a:r>
              <a:rPr lang="en-US" sz="1200" dirty="0"/>
              <a:t>causal attributions </a:t>
            </a:r>
          </a:p>
        </p:txBody>
      </p:sp>
      <p:cxnSp>
        <p:nvCxnSpPr>
          <p:cNvPr id="97" name="Gerader Verbinder 96"/>
          <p:cNvCxnSpPr/>
          <p:nvPr/>
        </p:nvCxnSpPr>
        <p:spPr>
          <a:xfrm>
            <a:off x="2719108" y="7048955"/>
            <a:ext cx="402984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7" name="Gerader Verbinder 106"/>
          <p:cNvCxnSpPr/>
          <p:nvPr/>
        </p:nvCxnSpPr>
        <p:spPr>
          <a:xfrm>
            <a:off x="2997218" y="2559288"/>
            <a:ext cx="1044008" cy="4701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8" name="Abgerundetes Rechteck 107"/>
          <p:cNvSpPr/>
          <p:nvPr/>
        </p:nvSpPr>
        <p:spPr>
          <a:xfrm>
            <a:off x="1524550" y="3224194"/>
            <a:ext cx="2966232" cy="541682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9" name="Abgerundetes Rechteck 108"/>
          <p:cNvSpPr/>
          <p:nvPr/>
        </p:nvSpPr>
        <p:spPr>
          <a:xfrm>
            <a:off x="2376374" y="8689117"/>
            <a:ext cx="1070599" cy="243118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11" name="Gerade Verbindung mit Pfeil 110"/>
          <p:cNvCxnSpPr/>
          <p:nvPr/>
        </p:nvCxnSpPr>
        <p:spPr>
          <a:xfrm flipH="1">
            <a:off x="4542195" y="3077834"/>
            <a:ext cx="789824" cy="26607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5210804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404411"/>
            <a:ext cx="4428000" cy="270183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3496043"/>
            <a:ext cx="4428000" cy="2701832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6590722"/>
            <a:ext cx="4428000" cy="2701832"/>
          </a:xfrm>
          <a:prstGeom prst="rect">
            <a:avLst/>
          </a:prstGeom>
        </p:spPr>
      </p:pic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b="91310"/>
          <a:stretch/>
        </p:blipFill>
        <p:spPr>
          <a:xfrm>
            <a:off x="1432696" y="697334"/>
            <a:ext cx="3324179" cy="196209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>
          <a:xfrm>
            <a:off x="1673757" y="979681"/>
            <a:ext cx="2842056" cy="856030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829" noProof="1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4237" y="1298698"/>
            <a:ext cx="1921095" cy="217995"/>
          </a:xfrm>
          <a:prstGeom prst="rect">
            <a:avLst/>
          </a:prstGeom>
        </p:spPr>
      </p:pic>
      <p:sp>
        <p:nvSpPr>
          <p:cNvPr id="11" name="Rechteck 10"/>
          <p:cNvSpPr/>
          <p:nvPr/>
        </p:nvSpPr>
        <p:spPr>
          <a:xfrm>
            <a:off x="1972685" y="1180841"/>
            <a:ext cx="2172426" cy="65401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9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What did your answers reveal? </a:t>
            </a:r>
          </a:p>
          <a:p>
            <a:endParaRPr lang="de-DE" sz="1914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972685" y="1026383"/>
            <a:ext cx="2603157" cy="3737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You have indicated that you have felt affected by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low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spirits</a:t>
            </a:r>
            <a:r>
              <a:rPr lang="de-DE" sz="400" noProof="1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,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sleep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disturbances,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and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 loss of energy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during the past two weeks. According to our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evaluation*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these are  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134237" y="1298156"/>
            <a:ext cx="60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no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681972" y="1301249"/>
            <a:ext cx="753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moderate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435823" y="1301249"/>
            <a:ext cx="674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    significant 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972685" y="1516151"/>
            <a:ext cx="2082647" cy="215444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These symptoms are most likely indications of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</a:rPr>
              <a:t>depression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. Please note that this feedback does not take the place of a thorough medical diagnosis.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972685" y="1703455"/>
            <a:ext cx="681597" cy="1384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300" noProof="1" smtClean="0">
                <a:solidFill>
                  <a:srgbClr val="020044"/>
                </a:solidFill>
              </a:rPr>
              <a:t>*The evaluation is based on the</a:t>
            </a:r>
            <a:endParaRPr lang="de-DE" sz="300" noProof="1">
              <a:solidFill>
                <a:srgbClr val="020044"/>
              </a:solidFill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/>
          <a:srcRect l="815" t="-1" b="3317"/>
          <a:stretch/>
        </p:blipFill>
        <p:spPr>
          <a:xfrm>
            <a:off x="2557436" y="1734389"/>
            <a:ext cx="434754" cy="81369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1389" y="1291370"/>
            <a:ext cx="594844" cy="232649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789539" y="9618896"/>
            <a:ext cx="646801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611505" algn="just">
              <a:spcAft>
                <a:spcPts val="1200"/>
              </a:spcAft>
            </a:pPr>
            <a:r>
              <a:rPr lang="en-US" sz="1400" noProof="1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Supplemental B</a:t>
            </a:r>
            <a:r>
              <a:rPr lang="en-US" sz="1400" noProof="1" smtClean="0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. Exemplary tailored feedback for participants who indicate that their symptoms are indications of depression but that they do not worry about them (English translation)</a:t>
            </a:r>
            <a:r>
              <a:rPr lang="en-US" sz="1400" noProof="1" smtClean="0">
                <a:solidFill>
                  <a:srgbClr val="333333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en-US" sz="1400" noProof="1">
              <a:solidFill>
                <a:srgbClr val="333333"/>
              </a:solidFill>
              <a:latin typeface="+mj-lt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68" name="Grafik 6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02817" y="1960633"/>
            <a:ext cx="2772000" cy="386175"/>
          </a:xfrm>
          <a:prstGeom prst="rect">
            <a:avLst/>
          </a:prstGeom>
        </p:spPr>
      </p:pic>
      <p:sp>
        <p:nvSpPr>
          <p:cNvPr id="69" name="Textfeld 68"/>
          <p:cNvSpPr txBox="1"/>
          <p:nvPr/>
        </p:nvSpPr>
        <p:spPr>
          <a:xfrm>
            <a:off x="1727202" y="1975808"/>
            <a:ext cx="1355960" cy="246478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Do you think your symptoms are </a:t>
            </a:r>
            <a:r>
              <a:rPr lang="en-GB" sz="501" b="1" dirty="0">
                <a:solidFill>
                  <a:srgbClr val="020044"/>
                </a:solidFill>
                <a:latin typeface="Constantia" panose="02030602050306030303" pitchFamily="18" charset="0"/>
              </a:rPr>
              <a:t>indications </a:t>
            </a:r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of depression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118219" y="1981179"/>
            <a:ext cx="1394813" cy="169405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Are you worried about your symptoms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2011870" y="2189515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2265901" y="2189616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2522367" y="2189491"/>
            <a:ext cx="334322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maybe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3532034" y="2188419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785903" y="2187136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4469486" y="1967487"/>
            <a:ext cx="4571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78" name="Textfeld 77"/>
          <p:cNvSpPr txBox="1"/>
          <p:nvPr/>
        </p:nvSpPr>
        <p:spPr>
          <a:xfrm>
            <a:off x="1652262" y="3872640"/>
            <a:ext cx="171579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Depression isn’t that bad – or is i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pic>
        <p:nvPicPr>
          <p:cNvPr id="105" name="Grafik 104"/>
          <p:cNvPicPr>
            <a:picLocks noChangeAspect="1"/>
          </p:cNvPicPr>
          <p:nvPr/>
        </p:nvPicPr>
        <p:blipFill rotWithShape="1">
          <a:blip r:embed="rId8"/>
          <a:srcRect b="54466"/>
          <a:stretch/>
        </p:blipFill>
        <p:spPr>
          <a:xfrm>
            <a:off x="1467647" y="6943742"/>
            <a:ext cx="3231029" cy="877751"/>
          </a:xfrm>
          <a:prstGeom prst="rect">
            <a:avLst/>
          </a:prstGeom>
        </p:spPr>
      </p:pic>
      <p:sp>
        <p:nvSpPr>
          <p:cNvPr id="89" name="Textfeld 88"/>
          <p:cNvSpPr txBox="1"/>
          <p:nvPr/>
        </p:nvSpPr>
        <p:spPr>
          <a:xfrm>
            <a:off x="2529323" y="4907073"/>
            <a:ext cx="191261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         And now – what should I do firs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pic>
        <p:nvPicPr>
          <p:cNvPr id="99" name="Grafik 9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55453" y="7089503"/>
            <a:ext cx="2217432" cy="203844"/>
          </a:xfrm>
          <a:prstGeom prst="rect">
            <a:avLst/>
          </a:prstGeom>
        </p:spPr>
      </p:pic>
      <p:pic>
        <p:nvPicPr>
          <p:cNvPr id="100" name="Grafik 9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56390" y="7529305"/>
            <a:ext cx="542472" cy="109812"/>
          </a:xfrm>
          <a:prstGeom prst="rect">
            <a:avLst/>
          </a:prstGeom>
        </p:spPr>
      </p:pic>
      <p:pic>
        <p:nvPicPr>
          <p:cNvPr id="101" name="Grafik 10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34305" y="7631529"/>
            <a:ext cx="589398" cy="112053"/>
          </a:xfrm>
          <a:prstGeom prst="rect">
            <a:avLst/>
          </a:prstGeom>
        </p:spPr>
      </p:pic>
      <p:pic>
        <p:nvPicPr>
          <p:cNvPr id="102" name="Grafik 10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22390" y="7631529"/>
            <a:ext cx="486260" cy="105252"/>
          </a:xfrm>
          <a:prstGeom prst="rect">
            <a:avLst/>
          </a:prstGeom>
        </p:spPr>
      </p:pic>
      <p:pic>
        <p:nvPicPr>
          <p:cNvPr id="103" name="Grafik 10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821350" y="7529305"/>
            <a:ext cx="533021" cy="162283"/>
          </a:xfrm>
          <a:prstGeom prst="rect">
            <a:avLst/>
          </a:prstGeom>
        </p:spPr>
      </p:pic>
      <p:pic>
        <p:nvPicPr>
          <p:cNvPr id="110" name="Grafik 10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32202" y="7399310"/>
            <a:ext cx="556437" cy="556437"/>
          </a:xfrm>
          <a:prstGeom prst="rect">
            <a:avLst/>
          </a:prstGeom>
          <a:solidFill>
            <a:schemeClr val="bg1"/>
          </a:solidFill>
        </p:spPr>
      </p:pic>
      <p:sp>
        <p:nvSpPr>
          <p:cNvPr id="113" name="Textfeld 112"/>
          <p:cNvSpPr txBox="1"/>
          <p:nvPr/>
        </p:nvSpPr>
        <p:spPr>
          <a:xfrm>
            <a:off x="2442499" y="6959733"/>
            <a:ext cx="1201127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b="1" noProof="1" smtClean="0">
                <a:solidFill>
                  <a:srgbClr val="000043"/>
                </a:solidFill>
                <a:latin typeface="Constantia" panose="02030602050306030303" pitchFamily="18" charset="0"/>
              </a:rPr>
              <a:t>How do I find an online therapy?</a:t>
            </a:r>
            <a:endParaRPr lang="de-DE" sz="500" b="1" noProof="1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2442499" y="7080141"/>
            <a:ext cx="126615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With a prescription from a doctor, the following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 </a:t>
            </a:r>
            <a:r>
              <a:rPr lang="de-DE" sz="400" noProof="1" smtClean="0">
                <a:solidFill>
                  <a:srgbClr val="000043"/>
                </a:solidFill>
              </a:rPr>
              <a:t>are fully covered by your public health insurance company </a:t>
            </a:r>
            <a:r>
              <a:rPr lang="de-DE" sz="400" b="1" noProof="1" smtClean="0">
                <a:solidFill>
                  <a:srgbClr val="40C5B1"/>
                </a:solidFill>
              </a:rPr>
              <a:t>ABC</a:t>
            </a:r>
            <a:r>
              <a:rPr lang="de-DE" sz="400" noProof="1" smtClean="0">
                <a:solidFill>
                  <a:srgbClr val="000043"/>
                </a:solidFill>
              </a:rPr>
              <a:t>:</a:t>
            </a:r>
            <a:endParaRPr lang="de-DE" sz="400" noProof="1">
              <a:solidFill>
                <a:srgbClr val="000043"/>
              </a:solidFill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2594399" y="7430634"/>
            <a:ext cx="1007372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Deprexis online therapy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2593637" y="7332905"/>
            <a:ext cx="872679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Selfapy-Course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2576208" y="7712670"/>
            <a:ext cx="87267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MindDoc (Schön-Klinik)</a:t>
            </a:r>
          </a:p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HelloBette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2461793" y="7538021"/>
            <a:ext cx="122684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Some health insurance companies also cover the cost of other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</a:t>
            </a:r>
            <a:r>
              <a:rPr lang="de-DE" sz="400" noProof="1" smtClean="0">
                <a:solidFill>
                  <a:srgbClr val="000043"/>
                </a:solidFill>
              </a:rPr>
              <a:t>, such as:</a:t>
            </a:r>
            <a:endParaRPr lang="de-DE" sz="400" noProof="1">
              <a:solidFill>
                <a:srgbClr val="000043"/>
              </a:solidFill>
            </a:endParaRPr>
          </a:p>
        </p:txBody>
      </p:sp>
      <p:pic>
        <p:nvPicPr>
          <p:cNvPr id="119" name="Grafik 118"/>
          <p:cNvPicPr>
            <a:picLocks noChangeAspect="1"/>
          </p:cNvPicPr>
          <p:nvPr/>
        </p:nvPicPr>
        <p:blipFill rotWithShape="1">
          <a:blip r:embed="rId15"/>
          <a:srcRect b="15014"/>
          <a:stretch/>
        </p:blipFill>
        <p:spPr>
          <a:xfrm>
            <a:off x="2480802" y="7466833"/>
            <a:ext cx="112221" cy="84283"/>
          </a:xfrm>
          <a:prstGeom prst="rect">
            <a:avLst/>
          </a:prstGeom>
        </p:spPr>
      </p:pic>
      <p:cxnSp>
        <p:nvCxnSpPr>
          <p:cNvPr id="131" name="Gerade Verbindung mit Pfeil 130"/>
          <p:cNvCxnSpPr/>
          <p:nvPr/>
        </p:nvCxnSpPr>
        <p:spPr>
          <a:xfrm flipH="1">
            <a:off x="3907412" y="980628"/>
            <a:ext cx="1509668" cy="157215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>
            <a:off x="5417080" y="735057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profile</a:t>
            </a:r>
            <a:endParaRPr lang="en-US" sz="1200" dirty="0"/>
          </a:p>
        </p:txBody>
      </p:sp>
      <p:sp>
        <p:nvSpPr>
          <p:cNvPr id="133" name="Abgerundetes Rechteck 132"/>
          <p:cNvSpPr/>
          <p:nvPr/>
        </p:nvSpPr>
        <p:spPr>
          <a:xfrm>
            <a:off x="1609611" y="1873278"/>
            <a:ext cx="2966232" cy="541682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34" name="Gerade Verbindung mit Pfeil 133"/>
          <p:cNvCxnSpPr/>
          <p:nvPr/>
        </p:nvCxnSpPr>
        <p:spPr>
          <a:xfrm flipH="1">
            <a:off x="4627256" y="1726918"/>
            <a:ext cx="789824" cy="26607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7" name="Textfeld 136"/>
          <p:cNvSpPr txBox="1"/>
          <p:nvPr/>
        </p:nvSpPr>
        <p:spPr>
          <a:xfrm>
            <a:off x="5417080" y="3414605"/>
            <a:ext cx="1382592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</a:t>
            </a:r>
            <a:r>
              <a:rPr lang="en-US" sz="1200" dirty="0" smtClean="0"/>
              <a:t>nformation on negative consequences of depression</a:t>
            </a:r>
            <a:endParaRPr lang="en-US" sz="1200" dirty="0"/>
          </a:p>
        </p:txBody>
      </p:sp>
      <p:pic>
        <p:nvPicPr>
          <p:cNvPr id="147" name="Grafik 146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746093" y="8019054"/>
            <a:ext cx="781535" cy="781535"/>
          </a:xfrm>
          <a:prstGeom prst="rect">
            <a:avLst/>
          </a:prstGeom>
        </p:spPr>
      </p:pic>
      <p:sp>
        <p:nvSpPr>
          <p:cNvPr id="155" name="Textfeld 154"/>
          <p:cNvSpPr txBox="1"/>
          <p:nvPr/>
        </p:nvSpPr>
        <p:spPr>
          <a:xfrm>
            <a:off x="5417080" y="1493612"/>
            <a:ext cx="1300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questions</a:t>
            </a:r>
            <a:r>
              <a:rPr lang="en-US" dirty="0" smtClean="0"/>
              <a:t> </a:t>
            </a:r>
            <a:endParaRPr lang="en-US" dirty="0"/>
          </a:p>
        </p:txBody>
      </p:sp>
      <p:cxnSp>
        <p:nvCxnSpPr>
          <p:cNvPr id="158" name="Gerader Verbinder 157"/>
          <p:cNvCxnSpPr/>
          <p:nvPr/>
        </p:nvCxnSpPr>
        <p:spPr>
          <a:xfrm>
            <a:off x="3082279" y="1208372"/>
            <a:ext cx="1044008" cy="4701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feld 166"/>
          <p:cNvSpPr txBox="1"/>
          <p:nvPr/>
        </p:nvSpPr>
        <p:spPr>
          <a:xfrm>
            <a:off x="5417080" y="6810267"/>
            <a:ext cx="16329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online therapies offered by participant’s health insurance provider</a:t>
            </a:r>
            <a:endParaRPr lang="en-US" sz="1200" dirty="0"/>
          </a:p>
        </p:txBody>
      </p:sp>
      <p:sp>
        <p:nvSpPr>
          <p:cNvPr id="91" name="Textfeld 90"/>
          <p:cNvSpPr txBox="1"/>
          <p:nvPr/>
        </p:nvSpPr>
        <p:spPr>
          <a:xfrm>
            <a:off x="1652262" y="4051623"/>
            <a:ext cx="1840003" cy="83099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400" dirty="0" smtClean="0">
                <a:solidFill>
                  <a:srgbClr val="020044"/>
                </a:solidFill>
              </a:rPr>
              <a:t>Depressive symptoms are often underestimated at first - but they are more than just being in bad mood:</a:t>
            </a:r>
          </a:p>
          <a:p>
            <a:endParaRPr lang="en-GB" sz="300" dirty="0" smtClean="0">
              <a:solidFill>
                <a:srgbClr val="020044"/>
              </a:solidFill>
            </a:endParaRPr>
          </a:p>
          <a:p>
            <a:pPr marL="171444" indent="-171444">
              <a:buFont typeface="Arial" panose="020B0604020202020204" pitchFamily="34" charset="0"/>
              <a:buChar char="•"/>
            </a:pPr>
            <a:r>
              <a:rPr lang="en-GB" sz="400" dirty="0" smtClean="0">
                <a:solidFill>
                  <a:srgbClr val="020044"/>
                </a:solidFill>
              </a:rPr>
              <a:t>they have long-term negative consequences – for example, </a:t>
            </a:r>
            <a:r>
              <a:rPr lang="en-GB" sz="400" b="1" dirty="0" smtClean="0">
                <a:solidFill>
                  <a:srgbClr val="4FC3B0"/>
                </a:solidFill>
              </a:rPr>
              <a:t>the risk of developing cancer or dementia</a:t>
            </a:r>
            <a:r>
              <a:rPr lang="en-GB" sz="400" dirty="0" smtClean="0">
                <a:solidFill>
                  <a:srgbClr val="020044"/>
                </a:solidFill>
              </a:rPr>
              <a:t> is significantly increased</a:t>
            </a:r>
          </a:p>
          <a:p>
            <a:pPr marL="171444" indent="-171444">
              <a:buFont typeface="Arial" panose="020B0604020202020204" pitchFamily="34" charset="0"/>
              <a:buChar char="•"/>
            </a:pPr>
            <a:r>
              <a:rPr lang="en-GB" sz="400" dirty="0" smtClean="0">
                <a:solidFill>
                  <a:srgbClr val="020044"/>
                </a:solidFill>
              </a:rPr>
              <a:t>they can subside on their own, but without treatment they </a:t>
            </a:r>
            <a:r>
              <a:rPr lang="en-GB" sz="400" b="1" dirty="0" smtClean="0">
                <a:solidFill>
                  <a:srgbClr val="4FC3B0"/>
                </a:solidFill>
              </a:rPr>
              <a:t>often come back again</a:t>
            </a:r>
          </a:p>
          <a:p>
            <a:pPr marL="171444" indent="-171444">
              <a:buFont typeface="Arial" panose="020B0604020202020204" pitchFamily="34" charset="0"/>
              <a:buChar char="•"/>
            </a:pPr>
            <a:r>
              <a:rPr lang="en-GB" sz="400" dirty="0" smtClean="0">
                <a:solidFill>
                  <a:srgbClr val="020044"/>
                </a:solidFill>
              </a:rPr>
              <a:t>typical symptoms are for example </a:t>
            </a:r>
            <a:r>
              <a:rPr lang="en-GB" sz="400" b="1" dirty="0" smtClean="0">
                <a:solidFill>
                  <a:srgbClr val="4FC3B0"/>
                </a:solidFill>
              </a:rPr>
              <a:t>low spirits </a:t>
            </a:r>
            <a:r>
              <a:rPr lang="en-GB" sz="400" dirty="0" smtClean="0">
                <a:solidFill>
                  <a:srgbClr val="020044"/>
                </a:solidFill>
              </a:rPr>
              <a:t>and </a:t>
            </a:r>
            <a:r>
              <a:rPr lang="en-GB" sz="400" b="1" dirty="0" smtClean="0">
                <a:solidFill>
                  <a:srgbClr val="4FC3B0"/>
                </a:solidFill>
              </a:rPr>
              <a:t>sleep disturbances</a:t>
            </a:r>
          </a:p>
          <a:p>
            <a:pPr marL="171444" indent="-171444">
              <a:buFont typeface="Arial" panose="020B0604020202020204" pitchFamily="34" charset="0"/>
              <a:buChar char="•"/>
            </a:pPr>
            <a:r>
              <a:rPr lang="en-GB" sz="400" dirty="0" smtClean="0">
                <a:solidFill>
                  <a:srgbClr val="020044"/>
                </a:solidFill>
              </a:rPr>
              <a:t>triggers are for example </a:t>
            </a:r>
            <a:r>
              <a:rPr lang="en-GB" sz="400" b="1" dirty="0" smtClean="0">
                <a:solidFill>
                  <a:srgbClr val="4FC3B0"/>
                </a:solidFill>
              </a:rPr>
              <a:t>family problems</a:t>
            </a:r>
            <a:r>
              <a:rPr lang="en-GB" sz="400" dirty="0" smtClean="0">
                <a:solidFill>
                  <a:srgbClr val="020044"/>
                </a:solidFill>
              </a:rPr>
              <a:t>, </a:t>
            </a:r>
            <a:r>
              <a:rPr lang="en-GB" sz="400" b="1" dirty="0" smtClean="0">
                <a:solidFill>
                  <a:srgbClr val="4FC3B0"/>
                </a:solidFill>
              </a:rPr>
              <a:t>negative thinking patterns </a:t>
            </a:r>
            <a:r>
              <a:rPr lang="en-GB" sz="400" dirty="0" smtClean="0">
                <a:solidFill>
                  <a:srgbClr val="020044"/>
                </a:solidFill>
              </a:rPr>
              <a:t>or </a:t>
            </a:r>
            <a:r>
              <a:rPr lang="en-GB" sz="400" b="1" dirty="0" smtClean="0">
                <a:solidFill>
                  <a:srgbClr val="4FC3B0"/>
                </a:solidFill>
              </a:rPr>
              <a:t>diabetes</a:t>
            </a:r>
          </a:p>
          <a:p>
            <a:r>
              <a:rPr lang="de-DE" sz="400" noProof="1">
                <a:solidFill>
                  <a:srgbClr val="020044"/>
                </a:solidFill>
              </a:rPr>
              <a:t>More information can be found </a:t>
            </a:r>
            <a:r>
              <a:rPr lang="de-DE" sz="400" noProof="1" smtClean="0">
                <a:solidFill>
                  <a:srgbClr val="020044"/>
                </a:solidFill>
              </a:rPr>
              <a:t>at </a:t>
            </a:r>
            <a:endParaRPr lang="de-DE" sz="400" noProof="1">
              <a:solidFill>
                <a:srgbClr val="020044"/>
              </a:solidFill>
            </a:endParaRPr>
          </a:p>
          <a:p>
            <a:r>
              <a:rPr lang="en-GB" sz="400" b="1" dirty="0" smtClean="0">
                <a:solidFill>
                  <a:srgbClr val="4FC3B0"/>
                </a:solidFill>
              </a:rPr>
              <a:t> </a:t>
            </a:r>
            <a:endParaRPr lang="en-GB" sz="400" b="1" dirty="0">
              <a:solidFill>
                <a:srgbClr val="4FC3B0"/>
              </a:solidFill>
            </a:endParaRPr>
          </a:p>
        </p:txBody>
      </p:sp>
      <p:pic>
        <p:nvPicPr>
          <p:cNvPr id="92" name="Grafik 9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3600559" y="3939973"/>
            <a:ext cx="781535" cy="781535"/>
          </a:xfrm>
          <a:prstGeom prst="rect">
            <a:avLst/>
          </a:prstGeom>
        </p:spPr>
      </p:pic>
      <p:pic>
        <p:nvPicPr>
          <p:cNvPr id="94" name="Grafik 93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475010" y="4669344"/>
            <a:ext cx="137160" cy="104172"/>
          </a:xfrm>
          <a:prstGeom prst="rect">
            <a:avLst/>
          </a:prstGeom>
        </p:spPr>
      </p:pic>
      <p:sp>
        <p:nvSpPr>
          <p:cNvPr id="95" name="Textfeld 94"/>
          <p:cNvSpPr txBox="1"/>
          <p:nvPr/>
        </p:nvSpPr>
        <p:spPr>
          <a:xfrm>
            <a:off x="2529323" y="4644872"/>
            <a:ext cx="601861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" u="sng" noProof="1" smtClean="0">
                <a:solidFill>
                  <a:srgbClr val="292B64"/>
                </a:solidFill>
              </a:rPr>
              <a:t>www.psychenet.de</a:t>
            </a:r>
            <a:endParaRPr lang="de-DE" sz="400" u="sng" noProof="1">
              <a:solidFill>
                <a:srgbClr val="292B64"/>
              </a:solidFill>
            </a:endParaRPr>
          </a:p>
        </p:txBody>
      </p:sp>
      <p:cxnSp>
        <p:nvCxnSpPr>
          <p:cNvPr id="138" name="Gerade Verbindung mit Pfeil 137"/>
          <p:cNvCxnSpPr>
            <a:stCxn id="137" idx="1"/>
          </p:cNvCxnSpPr>
          <p:nvPr/>
        </p:nvCxnSpPr>
        <p:spPr>
          <a:xfrm flipH="1">
            <a:off x="3448887" y="3830104"/>
            <a:ext cx="1968193" cy="51332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7" name="Textfeld 106"/>
          <p:cNvSpPr txBox="1"/>
          <p:nvPr/>
        </p:nvSpPr>
        <p:spPr>
          <a:xfrm>
            <a:off x="5417080" y="4269529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ymptom profiles </a:t>
            </a:r>
          </a:p>
        </p:txBody>
      </p:sp>
      <p:cxnSp>
        <p:nvCxnSpPr>
          <p:cNvPr id="108" name="Gerade Verbindung mit Pfeil 107"/>
          <p:cNvCxnSpPr>
            <a:stCxn id="107" idx="1"/>
          </p:cNvCxnSpPr>
          <p:nvPr/>
        </p:nvCxnSpPr>
        <p:spPr>
          <a:xfrm flipH="1">
            <a:off x="3434171" y="4500362"/>
            <a:ext cx="1982909" cy="4604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/>
          <p:cNvCxnSpPr/>
          <p:nvPr/>
        </p:nvCxnSpPr>
        <p:spPr>
          <a:xfrm>
            <a:off x="2608133" y="4564193"/>
            <a:ext cx="738916" cy="2056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Gerader Verbinder 110"/>
          <p:cNvCxnSpPr/>
          <p:nvPr/>
        </p:nvCxnSpPr>
        <p:spPr>
          <a:xfrm flipV="1">
            <a:off x="2416349" y="4632224"/>
            <a:ext cx="924949" cy="1322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Gerader Verbinder 119"/>
          <p:cNvCxnSpPr/>
          <p:nvPr/>
        </p:nvCxnSpPr>
        <p:spPr>
          <a:xfrm>
            <a:off x="1904055" y="4685714"/>
            <a:ext cx="200790" cy="1305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Abgerundetes Rechteck 120"/>
          <p:cNvSpPr/>
          <p:nvPr/>
        </p:nvSpPr>
        <p:spPr>
          <a:xfrm>
            <a:off x="2461435" y="7338201"/>
            <a:ext cx="1070599" cy="243118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22" name="Textfeld 121"/>
          <p:cNvSpPr txBox="1"/>
          <p:nvPr/>
        </p:nvSpPr>
        <p:spPr>
          <a:xfrm>
            <a:off x="2718488" y="5059111"/>
            <a:ext cx="1561931" cy="33855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400" dirty="0" smtClean="0">
                <a:solidFill>
                  <a:srgbClr val="000043"/>
                </a:solidFill>
              </a:rPr>
              <a:t>Your symptoms are common – seeking advice helps. It is best to make an </a:t>
            </a:r>
            <a:r>
              <a:rPr lang="en-GB" sz="400" b="1" dirty="0" smtClean="0">
                <a:solidFill>
                  <a:srgbClr val="52C4B1"/>
                </a:solidFill>
              </a:rPr>
              <a:t>appointment with your general practitioner </a:t>
            </a:r>
            <a:r>
              <a:rPr lang="en-GB" sz="400" dirty="0" smtClean="0">
                <a:solidFill>
                  <a:srgbClr val="000043"/>
                </a:solidFill>
              </a:rPr>
              <a:t>to talk about your evaluation. You can print it out and take it with you to start the conversation.</a:t>
            </a:r>
            <a:endParaRPr lang="en-GB" sz="400" dirty="0">
              <a:solidFill>
                <a:srgbClr val="000043"/>
              </a:solidFill>
            </a:endParaRPr>
          </a:p>
        </p:txBody>
      </p:sp>
      <p:pic>
        <p:nvPicPr>
          <p:cNvPr id="123" name="Grafik 122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03042" y="5400470"/>
            <a:ext cx="122036" cy="113761"/>
          </a:xfrm>
          <a:prstGeom prst="rect">
            <a:avLst/>
          </a:prstGeom>
        </p:spPr>
      </p:pic>
      <p:sp>
        <p:nvSpPr>
          <p:cNvPr id="124" name="Textfeld 123"/>
          <p:cNvSpPr txBox="1"/>
          <p:nvPr/>
        </p:nvSpPr>
        <p:spPr>
          <a:xfrm>
            <a:off x="2844746" y="5397833"/>
            <a:ext cx="490333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Print your feedback </a:t>
            </a:r>
            <a:endParaRPr lang="en-GB" sz="300" u="sng" dirty="0"/>
          </a:p>
        </p:txBody>
      </p:sp>
      <p:pic>
        <p:nvPicPr>
          <p:cNvPr id="125" name="Grafik 124"/>
          <p:cNvPicPr>
            <a:picLocks noChangeAspect="1"/>
          </p:cNvPicPr>
          <p:nvPr/>
        </p:nvPicPr>
        <p:blipFill rotWithShape="1">
          <a:blip r:embed="rId15"/>
          <a:srcRect b="15014"/>
          <a:stretch/>
        </p:blipFill>
        <p:spPr>
          <a:xfrm>
            <a:off x="3245102" y="5397834"/>
            <a:ext cx="154984" cy="116399"/>
          </a:xfrm>
          <a:prstGeom prst="rect">
            <a:avLst/>
          </a:prstGeom>
        </p:spPr>
      </p:pic>
      <p:sp>
        <p:nvSpPr>
          <p:cNvPr id="126" name="Textfeld 125"/>
          <p:cNvSpPr txBox="1"/>
          <p:nvPr/>
        </p:nvSpPr>
        <p:spPr>
          <a:xfrm>
            <a:off x="3322594" y="5398350"/>
            <a:ext cx="545309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Make an appointment</a:t>
            </a:r>
            <a:endParaRPr lang="en-GB" sz="300" u="sng" dirty="0"/>
          </a:p>
        </p:txBody>
      </p:sp>
      <p:cxnSp>
        <p:nvCxnSpPr>
          <p:cNvPr id="127" name="Gerader Verbinder 126"/>
          <p:cNvCxnSpPr/>
          <p:nvPr/>
        </p:nvCxnSpPr>
        <p:spPr>
          <a:xfrm flipV="1">
            <a:off x="2987730" y="5223231"/>
            <a:ext cx="928579" cy="232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Gerade Verbindung mit Pfeil 159"/>
          <p:cNvCxnSpPr/>
          <p:nvPr/>
        </p:nvCxnSpPr>
        <p:spPr>
          <a:xfrm flipH="1" flipV="1">
            <a:off x="4280419" y="5208195"/>
            <a:ext cx="1101829" cy="321569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Gerade Verbindung mit Pfeil 127"/>
          <p:cNvCxnSpPr/>
          <p:nvPr/>
        </p:nvCxnSpPr>
        <p:spPr>
          <a:xfrm flipH="1" flipV="1">
            <a:off x="3434170" y="4644872"/>
            <a:ext cx="1948078" cy="356625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feld 128"/>
          <p:cNvSpPr txBox="1"/>
          <p:nvPr/>
        </p:nvSpPr>
        <p:spPr>
          <a:xfrm>
            <a:off x="5417080" y="4719261"/>
            <a:ext cx="15531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</a:t>
            </a:r>
            <a:r>
              <a:rPr lang="en-US" sz="1200" dirty="0"/>
              <a:t>causal attributions </a:t>
            </a:r>
          </a:p>
        </p:txBody>
      </p:sp>
      <p:sp>
        <p:nvSpPr>
          <p:cNvPr id="130" name="Textfeld 129"/>
          <p:cNvSpPr txBox="1"/>
          <p:nvPr/>
        </p:nvSpPr>
        <p:spPr>
          <a:xfrm>
            <a:off x="5409272" y="5393073"/>
            <a:ext cx="1382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pecialist preferences</a:t>
            </a:r>
          </a:p>
        </p:txBody>
      </p:sp>
      <p:pic>
        <p:nvPicPr>
          <p:cNvPr id="135" name="Grafik 134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4444" y="4867900"/>
            <a:ext cx="866068" cy="866068"/>
          </a:xfrm>
          <a:prstGeom prst="rect">
            <a:avLst/>
          </a:prstGeom>
        </p:spPr>
      </p:pic>
      <p:sp>
        <p:nvSpPr>
          <p:cNvPr id="136" name="Textfeld 135"/>
          <p:cNvSpPr txBox="1"/>
          <p:nvPr/>
        </p:nvSpPr>
        <p:spPr>
          <a:xfrm>
            <a:off x="1432696" y="7954020"/>
            <a:ext cx="191261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         Depression – how to treat i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39" name="Textfeld 138"/>
          <p:cNvSpPr txBox="1"/>
          <p:nvPr/>
        </p:nvSpPr>
        <p:spPr>
          <a:xfrm>
            <a:off x="1626674" y="8119518"/>
            <a:ext cx="1561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400" noProof="1">
                <a:solidFill>
                  <a:srgbClr val="020044"/>
                </a:solidFill>
              </a:rPr>
              <a:t>There are very good treatments for </a:t>
            </a:r>
            <a:r>
              <a:rPr lang="de-DE" sz="400" noProof="1" smtClean="0">
                <a:solidFill>
                  <a:srgbClr val="020044"/>
                </a:solidFill>
              </a:rPr>
              <a:t>depression</a:t>
            </a:r>
            <a:r>
              <a:rPr lang="en-GB" sz="400" dirty="0" smtClean="0">
                <a:solidFill>
                  <a:srgbClr val="000043"/>
                </a:solidFill>
              </a:rPr>
              <a:t> – especially when it occurs for the first time. </a:t>
            </a:r>
            <a:r>
              <a:rPr lang="en-GB" sz="400" b="1" dirty="0" smtClean="0">
                <a:solidFill>
                  <a:srgbClr val="52C4B1"/>
                </a:solidFill>
              </a:rPr>
              <a:t>Psychotherapy</a:t>
            </a:r>
            <a:r>
              <a:rPr lang="en-GB" sz="400" dirty="0" smtClean="0">
                <a:solidFill>
                  <a:srgbClr val="000043"/>
                </a:solidFill>
              </a:rPr>
              <a:t> or medication are most effective. </a:t>
            </a:r>
            <a:r>
              <a:rPr lang="en-GB" sz="400" b="1" dirty="0" smtClean="0">
                <a:solidFill>
                  <a:srgbClr val="52C4B1"/>
                </a:solidFill>
              </a:rPr>
              <a:t>Online therapies </a:t>
            </a:r>
            <a:r>
              <a:rPr lang="en-GB" sz="400" dirty="0" smtClean="0">
                <a:solidFill>
                  <a:srgbClr val="000043"/>
                </a:solidFill>
              </a:rPr>
              <a:t>are also readily available. Together with your health professional you can decide which treatment is best for you.</a:t>
            </a:r>
            <a:endParaRPr lang="en-GB" sz="400" dirty="0">
              <a:solidFill>
                <a:srgbClr val="000043"/>
              </a:solidFill>
            </a:endParaRPr>
          </a:p>
        </p:txBody>
      </p:sp>
      <p:sp>
        <p:nvSpPr>
          <p:cNvPr id="140" name="Textfeld 139"/>
          <p:cNvSpPr txBox="1"/>
          <p:nvPr/>
        </p:nvSpPr>
        <p:spPr>
          <a:xfrm>
            <a:off x="1625185" y="8506701"/>
            <a:ext cx="1725522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Exercise, sleep, and relaxation techniques can also help to support the therapy - </a:t>
            </a:r>
            <a:r>
              <a:rPr lang="de-DE" sz="400" b="1" noProof="1" smtClean="0">
                <a:solidFill>
                  <a:srgbClr val="4FC3B0"/>
                </a:solidFill>
              </a:rPr>
              <a:t>health courses </a:t>
            </a:r>
            <a:r>
              <a:rPr lang="de-DE" sz="400" noProof="1">
                <a:solidFill>
                  <a:srgbClr val="020044"/>
                </a:solidFill>
              </a:rPr>
              <a:t>in this field are supported by </a:t>
            </a:r>
            <a:r>
              <a:rPr lang="de-DE" sz="400" b="1" noProof="1">
                <a:solidFill>
                  <a:srgbClr val="52C4B1"/>
                </a:solidFill>
              </a:rPr>
              <a:t>your </a:t>
            </a:r>
            <a:r>
              <a:rPr lang="de-DE" sz="400" b="1" noProof="1" smtClean="0">
                <a:solidFill>
                  <a:srgbClr val="52C4B1"/>
                </a:solidFill>
              </a:rPr>
              <a:t>ABC (health insurance provder).</a:t>
            </a:r>
            <a:endParaRPr lang="de-DE" sz="400" b="1" noProof="1">
              <a:solidFill>
                <a:srgbClr val="52C4B1"/>
              </a:solidFill>
            </a:endParaRPr>
          </a:p>
        </p:txBody>
      </p:sp>
      <p:cxnSp>
        <p:nvCxnSpPr>
          <p:cNvPr id="149" name="Gerader Verbinder 148"/>
          <p:cNvCxnSpPr/>
          <p:nvPr/>
        </p:nvCxnSpPr>
        <p:spPr>
          <a:xfrm>
            <a:off x="2828171" y="8678704"/>
            <a:ext cx="360000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0" name="Gerade Verbindung mit Pfeil 149"/>
          <p:cNvCxnSpPr/>
          <p:nvPr/>
        </p:nvCxnSpPr>
        <p:spPr>
          <a:xfrm flipH="1">
            <a:off x="3286626" y="8591034"/>
            <a:ext cx="2130454" cy="53192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3" name="Textfeld 152"/>
          <p:cNvSpPr txBox="1"/>
          <p:nvPr/>
        </p:nvSpPr>
        <p:spPr>
          <a:xfrm>
            <a:off x="5417080" y="8338924"/>
            <a:ext cx="1443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health insurance </a:t>
            </a:r>
            <a:r>
              <a:rPr lang="en-US" sz="1200" dirty="0" smtClean="0"/>
              <a:t>provider</a:t>
            </a:r>
            <a:endParaRPr lang="en-US" sz="1200" dirty="0"/>
          </a:p>
        </p:txBody>
      </p:sp>
      <p:cxnSp>
        <p:nvCxnSpPr>
          <p:cNvPr id="154" name="Gerader Verbinder 153"/>
          <p:cNvCxnSpPr/>
          <p:nvPr/>
        </p:nvCxnSpPr>
        <p:spPr>
          <a:xfrm>
            <a:off x="1707542" y="8744986"/>
            <a:ext cx="402984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Abgerundetes Rechteck 160"/>
          <p:cNvSpPr/>
          <p:nvPr/>
        </p:nvSpPr>
        <p:spPr>
          <a:xfrm>
            <a:off x="1884752" y="4259241"/>
            <a:ext cx="1532003" cy="130750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112" name="Grafik 111"/>
          <p:cNvPicPr>
            <a:picLocks noChangeAspect="1"/>
          </p:cNvPicPr>
          <p:nvPr/>
        </p:nvPicPr>
        <p:blipFill rotWithShape="1">
          <a:blip r:embed="rId20"/>
          <a:srcRect t="1" b="11580"/>
          <a:stretch/>
        </p:blipFill>
        <p:spPr>
          <a:xfrm>
            <a:off x="2443131" y="6941228"/>
            <a:ext cx="1282543" cy="105645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162" name="Grafik 16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38418" y="7637828"/>
            <a:ext cx="589398" cy="112053"/>
          </a:xfrm>
          <a:prstGeom prst="rect">
            <a:avLst/>
          </a:prstGeom>
        </p:spPr>
      </p:pic>
      <p:pic>
        <p:nvPicPr>
          <p:cNvPr id="165" name="Grafik 164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26503" y="7637828"/>
            <a:ext cx="486260" cy="105252"/>
          </a:xfrm>
          <a:prstGeom prst="rect">
            <a:avLst/>
          </a:prstGeom>
        </p:spPr>
      </p:pic>
      <p:pic>
        <p:nvPicPr>
          <p:cNvPr id="166" name="Grafik 165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36315" y="7405609"/>
            <a:ext cx="556437" cy="556437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70" name="Grafik 169"/>
          <p:cNvPicPr>
            <a:picLocks noChangeAspect="1"/>
          </p:cNvPicPr>
          <p:nvPr/>
        </p:nvPicPr>
        <p:blipFill rotWithShape="1">
          <a:blip r:embed="rId20"/>
          <a:srcRect t="1" b="11580"/>
          <a:stretch/>
        </p:blipFill>
        <p:spPr>
          <a:xfrm>
            <a:off x="2447244" y="6947527"/>
            <a:ext cx="1282543" cy="105645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171" name="Textfeld 170"/>
          <p:cNvSpPr txBox="1"/>
          <p:nvPr/>
        </p:nvSpPr>
        <p:spPr>
          <a:xfrm>
            <a:off x="2446612" y="6966032"/>
            <a:ext cx="1201127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b="1" noProof="1" smtClean="0">
                <a:solidFill>
                  <a:srgbClr val="000043"/>
                </a:solidFill>
                <a:latin typeface="Constantia" panose="02030602050306030303" pitchFamily="18" charset="0"/>
              </a:rPr>
              <a:t>How do I find an online therapy?</a:t>
            </a:r>
            <a:endParaRPr lang="de-DE" sz="500" b="1" noProof="1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72" name="Textfeld 171"/>
          <p:cNvSpPr txBox="1"/>
          <p:nvPr/>
        </p:nvSpPr>
        <p:spPr>
          <a:xfrm>
            <a:off x="2446612" y="7086440"/>
            <a:ext cx="126615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With a prescription from a doctor, the following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 </a:t>
            </a:r>
            <a:r>
              <a:rPr lang="de-DE" sz="400" noProof="1" smtClean="0">
                <a:solidFill>
                  <a:srgbClr val="000043"/>
                </a:solidFill>
              </a:rPr>
              <a:t>are fully covered by your public health insurance company </a:t>
            </a:r>
            <a:r>
              <a:rPr lang="de-DE" sz="400" b="1" noProof="1" smtClean="0">
                <a:solidFill>
                  <a:srgbClr val="40C5B1"/>
                </a:solidFill>
              </a:rPr>
              <a:t>ABC</a:t>
            </a:r>
            <a:r>
              <a:rPr lang="de-DE" sz="400" noProof="1" smtClean="0">
                <a:solidFill>
                  <a:srgbClr val="000043"/>
                </a:solidFill>
              </a:rPr>
              <a:t>:</a:t>
            </a:r>
            <a:endParaRPr lang="de-DE" sz="400" noProof="1">
              <a:solidFill>
                <a:srgbClr val="000043"/>
              </a:solidFill>
            </a:endParaRPr>
          </a:p>
        </p:txBody>
      </p:sp>
      <p:sp>
        <p:nvSpPr>
          <p:cNvPr id="174" name="Textfeld 173"/>
          <p:cNvSpPr txBox="1"/>
          <p:nvPr/>
        </p:nvSpPr>
        <p:spPr>
          <a:xfrm>
            <a:off x="2598512" y="7436933"/>
            <a:ext cx="1007372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Deprexis online therapy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76" name="Textfeld 175"/>
          <p:cNvSpPr txBox="1"/>
          <p:nvPr/>
        </p:nvSpPr>
        <p:spPr>
          <a:xfrm>
            <a:off x="2597750" y="7339204"/>
            <a:ext cx="872679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Selfapy-Course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77" name="Textfeld 176"/>
          <p:cNvSpPr txBox="1"/>
          <p:nvPr/>
        </p:nvSpPr>
        <p:spPr>
          <a:xfrm>
            <a:off x="2580321" y="7718969"/>
            <a:ext cx="87267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MindDoc (Schön-Klinik)</a:t>
            </a:r>
          </a:p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HelloBette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78" name="Textfeld 177"/>
          <p:cNvSpPr txBox="1"/>
          <p:nvPr/>
        </p:nvSpPr>
        <p:spPr>
          <a:xfrm>
            <a:off x="2465906" y="7544320"/>
            <a:ext cx="122684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Some health insurance companies also cover the cost of other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</a:t>
            </a:r>
            <a:r>
              <a:rPr lang="de-DE" sz="400" noProof="1" smtClean="0">
                <a:solidFill>
                  <a:srgbClr val="000043"/>
                </a:solidFill>
              </a:rPr>
              <a:t>, such as:</a:t>
            </a:r>
            <a:endParaRPr lang="de-DE" sz="400" noProof="1">
              <a:solidFill>
                <a:srgbClr val="000043"/>
              </a:solidFill>
            </a:endParaRPr>
          </a:p>
        </p:txBody>
      </p:sp>
      <p:pic>
        <p:nvPicPr>
          <p:cNvPr id="179" name="Grafik 178"/>
          <p:cNvPicPr>
            <a:picLocks noChangeAspect="1"/>
          </p:cNvPicPr>
          <p:nvPr/>
        </p:nvPicPr>
        <p:blipFill rotWithShape="1">
          <a:blip r:embed="rId15"/>
          <a:srcRect b="15014"/>
          <a:stretch/>
        </p:blipFill>
        <p:spPr>
          <a:xfrm>
            <a:off x="2484915" y="7473132"/>
            <a:ext cx="112221" cy="84283"/>
          </a:xfrm>
          <a:prstGeom prst="rect">
            <a:avLst/>
          </a:prstGeom>
        </p:spPr>
      </p:pic>
      <p:sp>
        <p:nvSpPr>
          <p:cNvPr id="180" name="Abgerundetes Rechteck 179"/>
          <p:cNvSpPr/>
          <p:nvPr/>
        </p:nvSpPr>
        <p:spPr>
          <a:xfrm>
            <a:off x="2465548" y="7344500"/>
            <a:ext cx="1070599" cy="243118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64" name="Gerade Verbindung mit Pfeil 163"/>
          <p:cNvCxnSpPr/>
          <p:nvPr/>
        </p:nvCxnSpPr>
        <p:spPr>
          <a:xfrm flipH="1">
            <a:off x="3690379" y="7171225"/>
            <a:ext cx="1684061" cy="295504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612637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404411"/>
            <a:ext cx="4428000" cy="270183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3496043"/>
            <a:ext cx="4428000" cy="2701832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6590722"/>
            <a:ext cx="4428000" cy="2701832"/>
          </a:xfrm>
          <a:prstGeom prst="rect">
            <a:avLst/>
          </a:prstGeom>
        </p:spPr>
      </p:pic>
      <p:sp>
        <p:nvSpPr>
          <p:cNvPr id="165" name="Textfeld 164"/>
          <p:cNvSpPr txBox="1"/>
          <p:nvPr/>
        </p:nvSpPr>
        <p:spPr>
          <a:xfrm>
            <a:off x="1432696" y="7954020"/>
            <a:ext cx="191261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         Depression – how to treat i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b="91310"/>
          <a:stretch/>
        </p:blipFill>
        <p:spPr>
          <a:xfrm>
            <a:off x="1432696" y="697334"/>
            <a:ext cx="3324179" cy="196209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>
          <a:xfrm>
            <a:off x="1673757" y="979681"/>
            <a:ext cx="2842056" cy="856030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829" noProof="1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4237" y="1298698"/>
            <a:ext cx="1921095" cy="217995"/>
          </a:xfrm>
          <a:prstGeom prst="rect">
            <a:avLst/>
          </a:prstGeom>
        </p:spPr>
      </p:pic>
      <p:sp>
        <p:nvSpPr>
          <p:cNvPr id="11" name="Rechteck 10"/>
          <p:cNvSpPr/>
          <p:nvPr/>
        </p:nvSpPr>
        <p:spPr>
          <a:xfrm>
            <a:off x="1972685" y="1180841"/>
            <a:ext cx="2172426" cy="65401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9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What did your answers reveal? </a:t>
            </a:r>
          </a:p>
          <a:p>
            <a:endParaRPr lang="de-DE" sz="1914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972685" y="1026383"/>
            <a:ext cx="2603157" cy="3737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You have indicated that you have felt affected by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low spirits</a:t>
            </a:r>
            <a:r>
              <a:rPr lang="de-DE" sz="400" noProof="1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,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sleep disturbances, </a:t>
            </a:r>
            <a:r>
              <a:rPr lang="de-DE" sz="400" noProof="1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and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 loss of energy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during the past two weeks. According to our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evaluation*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these are  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134237" y="1298156"/>
            <a:ext cx="60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no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681972" y="1301249"/>
            <a:ext cx="753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moderate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435823" y="1301249"/>
            <a:ext cx="674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    significant 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972685" y="1516151"/>
            <a:ext cx="2082647" cy="215444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These symptoms are most likely indications of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</a:rPr>
              <a:t>depression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. Please note that this feedback does not take the place of a thorough medical diagnosis.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972685" y="1703455"/>
            <a:ext cx="681597" cy="1384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300" noProof="1" smtClean="0">
                <a:solidFill>
                  <a:srgbClr val="020044"/>
                </a:solidFill>
              </a:rPr>
              <a:t>*The evaluation is based on the</a:t>
            </a:r>
            <a:endParaRPr lang="de-DE" sz="300" noProof="1">
              <a:solidFill>
                <a:srgbClr val="020044"/>
              </a:solidFill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/>
          <a:srcRect l="815" t="-1" b="3317"/>
          <a:stretch/>
        </p:blipFill>
        <p:spPr>
          <a:xfrm>
            <a:off x="2557436" y="1734389"/>
            <a:ext cx="434754" cy="81369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1389" y="1291370"/>
            <a:ext cx="594844" cy="232649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789539" y="9618896"/>
            <a:ext cx="646801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611505" algn="just">
              <a:spcAft>
                <a:spcPts val="1200"/>
              </a:spcAft>
            </a:pPr>
            <a:r>
              <a:rPr lang="en-US" sz="1400" noProof="1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Supplemental B. </a:t>
            </a:r>
            <a:r>
              <a:rPr lang="en-US" sz="1400" noProof="1" smtClean="0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 Exemplary tailored feedback for participants who indicate that their symptoms are not indications of depression but that they worry about them (English translation)</a:t>
            </a:r>
            <a:r>
              <a:rPr lang="en-US" sz="1400" noProof="1" smtClean="0">
                <a:solidFill>
                  <a:srgbClr val="333333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en-US" sz="1400" noProof="1">
              <a:solidFill>
                <a:srgbClr val="333333"/>
              </a:solidFill>
              <a:latin typeface="+mj-lt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68" name="Grafik 67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702817" y="1960633"/>
            <a:ext cx="2772000" cy="386175"/>
          </a:xfrm>
          <a:prstGeom prst="rect">
            <a:avLst/>
          </a:prstGeom>
        </p:spPr>
      </p:pic>
      <p:sp>
        <p:nvSpPr>
          <p:cNvPr id="69" name="Textfeld 68"/>
          <p:cNvSpPr txBox="1"/>
          <p:nvPr/>
        </p:nvSpPr>
        <p:spPr>
          <a:xfrm>
            <a:off x="1727202" y="1975808"/>
            <a:ext cx="1355960" cy="246478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Do you think your symptoms are </a:t>
            </a:r>
            <a:r>
              <a:rPr lang="en-GB" sz="501" b="1" dirty="0">
                <a:solidFill>
                  <a:srgbClr val="020044"/>
                </a:solidFill>
                <a:latin typeface="Constantia" panose="02030602050306030303" pitchFamily="18" charset="0"/>
              </a:rPr>
              <a:t>indications </a:t>
            </a:r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of depression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70" name="Textfeld 69"/>
          <p:cNvSpPr txBox="1"/>
          <p:nvPr/>
        </p:nvSpPr>
        <p:spPr>
          <a:xfrm>
            <a:off x="3118219" y="1981179"/>
            <a:ext cx="1394813" cy="169405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Are you worried about your symptoms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71" name="Textfeld 70"/>
          <p:cNvSpPr txBox="1"/>
          <p:nvPr/>
        </p:nvSpPr>
        <p:spPr>
          <a:xfrm>
            <a:off x="2011870" y="2189515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2" name="Textfeld 71"/>
          <p:cNvSpPr txBox="1"/>
          <p:nvPr/>
        </p:nvSpPr>
        <p:spPr>
          <a:xfrm>
            <a:off x="2265901" y="2189616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3" name="Textfeld 72"/>
          <p:cNvSpPr txBox="1"/>
          <p:nvPr/>
        </p:nvSpPr>
        <p:spPr>
          <a:xfrm>
            <a:off x="2522367" y="2189491"/>
            <a:ext cx="334322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maybe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4" name="Textfeld 73"/>
          <p:cNvSpPr txBox="1"/>
          <p:nvPr/>
        </p:nvSpPr>
        <p:spPr>
          <a:xfrm>
            <a:off x="3532034" y="2188419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5" name="Textfeld 74"/>
          <p:cNvSpPr txBox="1"/>
          <p:nvPr/>
        </p:nvSpPr>
        <p:spPr>
          <a:xfrm>
            <a:off x="3785903" y="2187136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76" name="Textfeld 75"/>
          <p:cNvSpPr txBox="1"/>
          <p:nvPr/>
        </p:nvSpPr>
        <p:spPr>
          <a:xfrm>
            <a:off x="4469486" y="1967487"/>
            <a:ext cx="4571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pic>
        <p:nvPicPr>
          <p:cNvPr id="105" name="Grafik 104"/>
          <p:cNvPicPr>
            <a:picLocks noChangeAspect="1"/>
          </p:cNvPicPr>
          <p:nvPr/>
        </p:nvPicPr>
        <p:blipFill rotWithShape="1">
          <a:blip r:embed="rId8"/>
          <a:srcRect b="54466"/>
          <a:stretch/>
        </p:blipFill>
        <p:spPr>
          <a:xfrm>
            <a:off x="1467647" y="6943742"/>
            <a:ext cx="3231029" cy="877751"/>
          </a:xfrm>
          <a:prstGeom prst="rect">
            <a:avLst/>
          </a:prstGeom>
        </p:spPr>
      </p:pic>
      <p:pic>
        <p:nvPicPr>
          <p:cNvPr id="99" name="Grafik 9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055453" y="7089503"/>
            <a:ext cx="2217432" cy="203844"/>
          </a:xfrm>
          <a:prstGeom prst="rect">
            <a:avLst/>
          </a:prstGeom>
        </p:spPr>
      </p:pic>
      <p:pic>
        <p:nvPicPr>
          <p:cNvPr id="100" name="Grafik 9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856390" y="7529305"/>
            <a:ext cx="542472" cy="109812"/>
          </a:xfrm>
          <a:prstGeom prst="rect">
            <a:avLst/>
          </a:prstGeom>
        </p:spPr>
      </p:pic>
      <p:pic>
        <p:nvPicPr>
          <p:cNvPr id="101" name="Grafik 100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2534305" y="7631529"/>
            <a:ext cx="589398" cy="112053"/>
          </a:xfrm>
          <a:prstGeom prst="rect">
            <a:avLst/>
          </a:prstGeom>
        </p:spPr>
      </p:pic>
      <p:pic>
        <p:nvPicPr>
          <p:cNvPr id="102" name="Grafik 10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222390" y="7631529"/>
            <a:ext cx="486260" cy="105252"/>
          </a:xfrm>
          <a:prstGeom prst="rect">
            <a:avLst/>
          </a:prstGeom>
        </p:spPr>
      </p:pic>
      <p:pic>
        <p:nvPicPr>
          <p:cNvPr id="103" name="Grafik 102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821350" y="7529305"/>
            <a:ext cx="533021" cy="162283"/>
          </a:xfrm>
          <a:prstGeom prst="rect">
            <a:avLst/>
          </a:prstGeom>
        </p:spPr>
      </p:pic>
      <p:pic>
        <p:nvPicPr>
          <p:cNvPr id="110" name="Grafik 10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3132202" y="7399310"/>
            <a:ext cx="556437" cy="556437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12" name="Grafik 111"/>
          <p:cNvPicPr>
            <a:picLocks noChangeAspect="1"/>
          </p:cNvPicPr>
          <p:nvPr/>
        </p:nvPicPr>
        <p:blipFill rotWithShape="1">
          <a:blip r:embed="rId15"/>
          <a:srcRect t="1" b="11580"/>
          <a:stretch/>
        </p:blipFill>
        <p:spPr>
          <a:xfrm>
            <a:off x="2443131" y="6941228"/>
            <a:ext cx="1282543" cy="105645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113" name="Textfeld 112"/>
          <p:cNvSpPr txBox="1"/>
          <p:nvPr/>
        </p:nvSpPr>
        <p:spPr>
          <a:xfrm>
            <a:off x="2442499" y="6959733"/>
            <a:ext cx="1201127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b="1" noProof="1" smtClean="0">
                <a:solidFill>
                  <a:srgbClr val="000043"/>
                </a:solidFill>
                <a:latin typeface="Constantia" panose="02030602050306030303" pitchFamily="18" charset="0"/>
              </a:rPr>
              <a:t>How do I find an online therapy?</a:t>
            </a:r>
            <a:endParaRPr lang="de-DE" sz="500" b="1" noProof="1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2442499" y="7080141"/>
            <a:ext cx="126615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With a prescription from a doctor, the following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 </a:t>
            </a:r>
            <a:r>
              <a:rPr lang="de-DE" sz="400" noProof="1" smtClean="0">
                <a:solidFill>
                  <a:srgbClr val="000043"/>
                </a:solidFill>
              </a:rPr>
              <a:t>are fully covered by your public health insurance company </a:t>
            </a:r>
            <a:r>
              <a:rPr lang="de-DE" sz="400" b="1" noProof="1" smtClean="0">
                <a:solidFill>
                  <a:srgbClr val="40C5B1"/>
                </a:solidFill>
              </a:rPr>
              <a:t>ABC</a:t>
            </a:r>
            <a:r>
              <a:rPr lang="de-DE" sz="400" noProof="1" smtClean="0">
                <a:solidFill>
                  <a:srgbClr val="000043"/>
                </a:solidFill>
              </a:rPr>
              <a:t>:</a:t>
            </a:r>
            <a:endParaRPr lang="de-DE" sz="400" noProof="1">
              <a:solidFill>
                <a:srgbClr val="000043"/>
              </a:solidFill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2594399" y="7430634"/>
            <a:ext cx="1007372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Deprexis online therapy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2593637" y="7332905"/>
            <a:ext cx="872679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Selfapy-Course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2576208" y="7712670"/>
            <a:ext cx="87267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MindDoc (Schön-Klinik)</a:t>
            </a:r>
          </a:p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HelloBette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2461793" y="7538021"/>
            <a:ext cx="122684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Some health insurance companies also cover the cost of other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</a:t>
            </a:r>
            <a:r>
              <a:rPr lang="de-DE" sz="400" noProof="1" smtClean="0">
                <a:solidFill>
                  <a:srgbClr val="000043"/>
                </a:solidFill>
              </a:rPr>
              <a:t>, such as:</a:t>
            </a:r>
            <a:endParaRPr lang="de-DE" sz="400" noProof="1">
              <a:solidFill>
                <a:srgbClr val="000043"/>
              </a:solidFill>
            </a:endParaRPr>
          </a:p>
        </p:txBody>
      </p:sp>
      <p:pic>
        <p:nvPicPr>
          <p:cNvPr id="119" name="Grafik 118"/>
          <p:cNvPicPr>
            <a:picLocks noChangeAspect="1"/>
          </p:cNvPicPr>
          <p:nvPr/>
        </p:nvPicPr>
        <p:blipFill rotWithShape="1">
          <a:blip r:embed="rId16"/>
          <a:srcRect b="15014"/>
          <a:stretch/>
        </p:blipFill>
        <p:spPr>
          <a:xfrm>
            <a:off x="2480802" y="7466833"/>
            <a:ext cx="112221" cy="84283"/>
          </a:xfrm>
          <a:prstGeom prst="rect">
            <a:avLst/>
          </a:prstGeom>
        </p:spPr>
      </p:pic>
      <p:cxnSp>
        <p:nvCxnSpPr>
          <p:cNvPr id="131" name="Gerade Verbindung mit Pfeil 130"/>
          <p:cNvCxnSpPr>
            <a:stCxn id="132" idx="1"/>
          </p:cNvCxnSpPr>
          <p:nvPr/>
        </p:nvCxnSpPr>
        <p:spPr>
          <a:xfrm flipH="1">
            <a:off x="3907412" y="965890"/>
            <a:ext cx="1509668" cy="17195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>
            <a:off x="5417080" y="735057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profile</a:t>
            </a:r>
            <a:endParaRPr lang="en-US" sz="1200" dirty="0"/>
          </a:p>
        </p:txBody>
      </p:sp>
      <p:sp>
        <p:nvSpPr>
          <p:cNvPr id="155" name="Textfeld 154"/>
          <p:cNvSpPr txBox="1"/>
          <p:nvPr/>
        </p:nvSpPr>
        <p:spPr>
          <a:xfrm>
            <a:off x="5417080" y="1493612"/>
            <a:ext cx="1300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questions</a:t>
            </a:r>
            <a:r>
              <a:rPr lang="en-US" dirty="0" smtClean="0"/>
              <a:t> </a:t>
            </a:r>
            <a:endParaRPr lang="en-US" dirty="0"/>
          </a:p>
        </p:txBody>
      </p:sp>
      <p:cxnSp>
        <p:nvCxnSpPr>
          <p:cNvPr id="164" name="Gerade Verbindung mit Pfeil 163"/>
          <p:cNvCxnSpPr>
            <a:stCxn id="167" idx="1"/>
          </p:cNvCxnSpPr>
          <p:nvPr/>
        </p:nvCxnSpPr>
        <p:spPr>
          <a:xfrm flipH="1">
            <a:off x="3690380" y="7225766"/>
            <a:ext cx="1726700" cy="24096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feld 166"/>
          <p:cNvSpPr txBox="1"/>
          <p:nvPr/>
        </p:nvSpPr>
        <p:spPr>
          <a:xfrm>
            <a:off x="5417080" y="6810267"/>
            <a:ext cx="16329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online therapies offered by participant’s health insurance provider</a:t>
            </a:r>
            <a:endParaRPr lang="en-US" sz="1200" dirty="0"/>
          </a:p>
        </p:txBody>
      </p:sp>
      <p:cxnSp>
        <p:nvCxnSpPr>
          <p:cNvPr id="91" name="Gerader Verbinder 90"/>
          <p:cNvCxnSpPr/>
          <p:nvPr/>
        </p:nvCxnSpPr>
        <p:spPr>
          <a:xfrm>
            <a:off x="3082279" y="1208372"/>
            <a:ext cx="1044008" cy="4701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2" name="Abgerundetes Rechteck 91"/>
          <p:cNvSpPr/>
          <p:nvPr/>
        </p:nvSpPr>
        <p:spPr>
          <a:xfrm>
            <a:off x="1609611" y="1873278"/>
            <a:ext cx="2966232" cy="541682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4" name="Abgerundetes Rechteck 93"/>
          <p:cNvSpPr/>
          <p:nvPr/>
        </p:nvSpPr>
        <p:spPr>
          <a:xfrm>
            <a:off x="2461435" y="7338201"/>
            <a:ext cx="1070599" cy="243118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feld 94"/>
          <p:cNvSpPr txBox="1"/>
          <p:nvPr/>
        </p:nvSpPr>
        <p:spPr>
          <a:xfrm>
            <a:off x="1652262" y="3872640"/>
            <a:ext cx="171579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Depression – or something else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1652262" y="4051623"/>
            <a:ext cx="1840003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400" dirty="0">
                <a:solidFill>
                  <a:srgbClr val="020044"/>
                </a:solidFill>
              </a:rPr>
              <a:t>Depressive symptoms are often difficult to recognise. Get your own picture:</a:t>
            </a:r>
          </a:p>
          <a:p>
            <a:endParaRPr lang="en-GB" sz="200" dirty="0" smtClean="0">
              <a:solidFill>
                <a:srgbClr val="020044"/>
              </a:solidFill>
            </a:endParaRP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typical symptoms are for example </a:t>
            </a:r>
            <a:r>
              <a:rPr lang="en-GB" sz="400" b="1" dirty="0">
                <a:solidFill>
                  <a:srgbClr val="4FC3B0"/>
                </a:solidFill>
              </a:rPr>
              <a:t>low spirits </a:t>
            </a:r>
            <a:r>
              <a:rPr lang="en-GB" sz="400" dirty="0">
                <a:solidFill>
                  <a:srgbClr val="020044"/>
                </a:solidFill>
              </a:rPr>
              <a:t>and </a:t>
            </a:r>
            <a:r>
              <a:rPr lang="en-GB" sz="400" b="1" dirty="0">
                <a:solidFill>
                  <a:srgbClr val="4FC3B0"/>
                </a:solidFill>
              </a:rPr>
              <a:t>sleep disturbances</a:t>
            </a:r>
            <a:endParaRPr lang="en-GB" sz="400" dirty="0">
              <a:solidFill>
                <a:srgbClr val="020044"/>
              </a:solidFill>
            </a:endParaRP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depression is very common and </a:t>
            </a:r>
            <a:r>
              <a:rPr lang="en-GB" sz="400" b="1" dirty="0">
                <a:solidFill>
                  <a:srgbClr val="4FC3B0"/>
                </a:solidFill>
              </a:rPr>
              <a:t>women</a:t>
            </a:r>
            <a:r>
              <a:rPr lang="en-GB" sz="400" dirty="0">
                <a:solidFill>
                  <a:srgbClr val="020044"/>
                </a:solidFill>
              </a:rPr>
              <a:t> are particularly often affected</a:t>
            </a: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triggers are for example </a:t>
            </a:r>
            <a:r>
              <a:rPr lang="en-GB" sz="400" b="1" dirty="0">
                <a:solidFill>
                  <a:srgbClr val="4FC3B0"/>
                </a:solidFill>
              </a:rPr>
              <a:t>family problems</a:t>
            </a:r>
            <a:r>
              <a:rPr lang="en-GB" sz="400" dirty="0">
                <a:solidFill>
                  <a:srgbClr val="020044"/>
                </a:solidFill>
              </a:rPr>
              <a:t>, </a:t>
            </a:r>
            <a:r>
              <a:rPr lang="en-GB" sz="400" b="1" dirty="0">
                <a:solidFill>
                  <a:srgbClr val="4FC3B0"/>
                </a:solidFill>
              </a:rPr>
              <a:t>negative thinking patterns </a:t>
            </a:r>
            <a:r>
              <a:rPr lang="en-GB" sz="400" dirty="0">
                <a:solidFill>
                  <a:srgbClr val="020044"/>
                </a:solidFill>
              </a:rPr>
              <a:t>or </a:t>
            </a:r>
            <a:r>
              <a:rPr lang="en-GB" sz="400" b="1" dirty="0">
                <a:solidFill>
                  <a:srgbClr val="4FC3B0"/>
                </a:solidFill>
              </a:rPr>
              <a:t>diabetes</a:t>
            </a:r>
            <a:endParaRPr lang="en-GB" sz="400" dirty="0">
              <a:solidFill>
                <a:srgbClr val="020044"/>
              </a:solidFill>
            </a:endParaRP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symptoms can subside on their own, but without treatment they </a:t>
            </a:r>
            <a:r>
              <a:rPr lang="en-GB" sz="400" b="1" dirty="0">
                <a:solidFill>
                  <a:srgbClr val="4FC3B0"/>
                </a:solidFill>
              </a:rPr>
              <a:t>often come back </a:t>
            </a:r>
            <a:r>
              <a:rPr lang="en-GB" sz="400" b="1" dirty="0" smtClean="0">
                <a:solidFill>
                  <a:srgbClr val="4FC3B0"/>
                </a:solidFill>
              </a:rPr>
              <a:t>again</a:t>
            </a:r>
          </a:p>
          <a:p>
            <a:pPr marL="169863" indent="-80963">
              <a:buFont typeface="Arial" panose="020B0604020202020204" pitchFamily="34" charset="0"/>
              <a:buChar char="•"/>
            </a:pPr>
            <a:endParaRPr lang="en-GB" sz="300" b="1" dirty="0">
              <a:solidFill>
                <a:srgbClr val="4FC3B0"/>
              </a:solidFill>
            </a:endParaRPr>
          </a:p>
          <a:p>
            <a:r>
              <a:rPr lang="de-DE" sz="400" noProof="1" smtClean="0">
                <a:solidFill>
                  <a:srgbClr val="020044"/>
                </a:solidFill>
              </a:rPr>
              <a:t>More </a:t>
            </a:r>
            <a:r>
              <a:rPr lang="de-DE" sz="400" noProof="1">
                <a:solidFill>
                  <a:srgbClr val="020044"/>
                </a:solidFill>
              </a:rPr>
              <a:t>information can be found </a:t>
            </a:r>
            <a:r>
              <a:rPr lang="de-DE" sz="400" noProof="1" smtClean="0">
                <a:solidFill>
                  <a:srgbClr val="020044"/>
                </a:solidFill>
              </a:rPr>
              <a:t>at </a:t>
            </a:r>
            <a:endParaRPr lang="de-DE" sz="400" noProof="1">
              <a:solidFill>
                <a:srgbClr val="020044"/>
              </a:solidFill>
            </a:endParaRPr>
          </a:p>
          <a:p>
            <a:r>
              <a:rPr lang="en-GB" sz="400" b="1" dirty="0" smtClean="0">
                <a:solidFill>
                  <a:srgbClr val="4FC3B0"/>
                </a:solidFill>
              </a:rPr>
              <a:t> </a:t>
            </a:r>
            <a:endParaRPr lang="en-GB" sz="400" b="1" dirty="0">
              <a:solidFill>
                <a:srgbClr val="4FC3B0"/>
              </a:solidFill>
            </a:endParaRPr>
          </a:p>
        </p:txBody>
      </p:sp>
      <p:pic>
        <p:nvPicPr>
          <p:cNvPr id="98" name="Grafik 97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2470361" y="4561378"/>
            <a:ext cx="137160" cy="104172"/>
          </a:xfrm>
          <a:prstGeom prst="rect">
            <a:avLst/>
          </a:prstGeom>
        </p:spPr>
      </p:pic>
      <p:sp>
        <p:nvSpPr>
          <p:cNvPr id="104" name="Textfeld 103"/>
          <p:cNvSpPr txBox="1"/>
          <p:nvPr/>
        </p:nvSpPr>
        <p:spPr>
          <a:xfrm>
            <a:off x="2524674" y="4536906"/>
            <a:ext cx="601861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" u="sng" noProof="1" smtClean="0">
                <a:solidFill>
                  <a:srgbClr val="292B64"/>
                </a:solidFill>
              </a:rPr>
              <a:t>www.psychenet.de</a:t>
            </a:r>
            <a:endParaRPr lang="de-DE" sz="400" u="sng" noProof="1">
              <a:solidFill>
                <a:srgbClr val="292B64"/>
              </a:solidFill>
            </a:endParaRPr>
          </a:p>
        </p:txBody>
      </p:sp>
      <p:cxnSp>
        <p:nvCxnSpPr>
          <p:cNvPr id="107" name="Gerader Verbinder 106"/>
          <p:cNvCxnSpPr/>
          <p:nvPr/>
        </p:nvCxnSpPr>
        <p:spPr>
          <a:xfrm>
            <a:off x="2407138" y="4375119"/>
            <a:ext cx="937641" cy="365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/>
          <p:cNvCxnSpPr/>
          <p:nvPr/>
        </p:nvCxnSpPr>
        <p:spPr>
          <a:xfrm>
            <a:off x="2612153" y="4243990"/>
            <a:ext cx="735105" cy="1043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Abgerundetes Rechteck 119"/>
          <p:cNvSpPr/>
          <p:nvPr/>
        </p:nvSpPr>
        <p:spPr>
          <a:xfrm>
            <a:off x="1882798" y="4255068"/>
            <a:ext cx="1532003" cy="60169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1" name="Gerader Verbinder 120"/>
          <p:cNvCxnSpPr/>
          <p:nvPr/>
        </p:nvCxnSpPr>
        <p:spPr>
          <a:xfrm>
            <a:off x="1909833" y="4431266"/>
            <a:ext cx="195693" cy="366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" name="Grafik 12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600559" y="3939973"/>
            <a:ext cx="781535" cy="781535"/>
          </a:xfrm>
          <a:prstGeom prst="rect">
            <a:avLst/>
          </a:prstGeom>
        </p:spPr>
      </p:pic>
      <p:cxnSp>
        <p:nvCxnSpPr>
          <p:cNvPr id="125" name="Gerade Verbindung mit Pfeil 124"/>
          <p:cNvCxnSpPr>
            <a:stCxn id="178" idx="1"/>
          </p:cNvCxnSpPr>
          <p:nvPr/>
        </p:nvCxnSpPr>
        <p:spPr>
          <a:xfrm flipH="1">
            <a:off x="3368056" y="3609744"/>
            <a:ext cx="2049024" cy="576260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Gerade Verbindung mit Pfeil 125"/>
          <p:cNvCxnSpPr>
            <a:stCxn id="179" idx="1"/>
          </p:cNvCxnSpPr>
          <p:nvPr/>
        </p:nvCxnSpPr>
        <p:spPr>
          <a:xfrm flipH="1" flipV="1">
            <a:off x="3405352" y="4372305"/>
            <a:ext cx="2011728" cy="684792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Gerade Verbindung mit Pfeil 128"/>
          <p:cNvCxnSpPr>
            <a:stCxn id="180" idx="1"/>
          </p:cNvCxnSpPr>
          <p:nvPr/>
        </p:nvCxnSpPr>
        <p:spPr>
          <a:xfrm flipH="1" flipV="1">
            <a:off x="3466316" y="4285565"/>
            <a:ext cx="1950764" cy="29692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feld 129"/>
          <p:cNvSpPr txBox="1"/>
          <p:nvPr/>
        </p:nvSpPr>
        <p:spPr>
          <a:xfrm>
            <a:off x="2529323" y="4907073"/>
            <a:ext cx="191261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         And now – what should I do firs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2718488" y="5059111"/>
            <a:ext cx="156193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400" dirty="0" smtClean="0">
                <a:solidFill>
                  <a:srgbClr val="000043"/>
                </a:solidFill>
              </a:rPr>
              <a:t>To rule out depression, you should make an </a:t>
            </a:r>
            <a:r>
              <a:rPr lang="en-GB" sz="400" b="1" dirty="0" smtClean="0">
                <a:solidFill>
                  <a:srgbClr val="52C4B1"/>
                </a:solidFill>
              </a:rPr>
              <a:t>appointment with your general practitioner </a:t>
            </a:r>
            <a:r>
              <a:rPr lang="en-GB" sz="400" dirty="0" smtClean="0">
                <a:solidFill>
                  <a:srgbClr val="000043"/>
                </a:solidFill>
              </a:rPr>
              <a:t>to talk about your evaluation. You can print it out and take it with you to start the conversation.</a:t>
            </a:r>
            <a:endParaRPr lang="en-GB" sz="400" dirty="0">
              <a:solidFill>
                <a:srgbClr val="000043"/>
              </a:solidFill>
            </a:endParaRPr>
          </a:p>
        </p:txBody>
      </p:sp>
      <p:pic>
        <p:nvPicPr>
          <p:cNvPr id="136" name="Grafik 135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2803042" y="5400470"/>
            <a:ext cx="122036" cy="113761"/>
          </a:xfrm>
          <a:prstGeom prst="rect">
            <a:avLst/>
          </a:prstGeom>
        </p:spPr>
      </p:pic>
      <p:sp>
        <p:nvSpPr>
          <p:cNvPr id="139" name="Textfeld 138"/>
          <p:cNvSpPr txBox="1"/>
          <p:nvPr/>
        </p:nvSpPr>
        <p:spPr>
          <a:xfrm>
            <a:off x="2844746" y="5397833"/>
            <a:ext cx="490333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Print your feedback </a:t>
            </a:r>
            <a:endParaRPr lang="en-GB" sz="300" u="sng" dirty="0"/>
          </a:p>
        </p:txBody>
      </p:sp>
      <p:pic>
        <p:nvPicPr>
          <p:cNvPr id="140" name="Grafik 139"/>
          <p:cNvPicPr>
            <a:picLocks noChangeAspect="1"/>
          </p:cNvPicPr>
          <p:nvPr/>
        </p:nvPicPr>
        <p:blipFill rotWithShape="1">
          <a:blip r:embed="rId16"/>
          <a:srcRect b="15014"/>
          <a:stretch/>
        </p:blipFill>
        <p:spPr>
          <a:xfrm>
            <a:off x="3245102" y="5397834"/>
            <a:ext cx="154984" cy="116399"/>
          </a:xfrm>
          <a:prstGeom prst="rect">
            <a:avLst/>
          </a:prstGeom>
        </p:spPr>
      </p:pic>
      <p:sp>
        <p:nvSpPr>
          <p:cNvPr id="149" name="Textfeld 148"/>
          <p:cNvSpPr txBox="1"/>
          <p:nvPr/>
        </p:nvSpPr>
        <p:spPr>
          <a:xfrm>
            <a:off x="3322594" y="5398350"/>
            <a:ext cx="545309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Make an appointment</a:t>
            </a:r>
            <a:endParaRPr lang="en-GB" sz="300" u="sng" dirty="0"/>
          </a:p>
        </p:txBody>
      </p:sp>
      <p:cxnSp>
        <p:nvCxnSpPr>
          <p:cNvPr id="150" name="Gerader Verbinder 149"/>
          <p:cNvCxnSpPr/>
          <p:nvPr/>
        </p:nvCxnSpPr>
        <p:spPr>
          <a:xfrm flipV="1">
            <a:off x="2909944" y="5225143"/>
            <a:ext cx="426683" cy="3073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" name="Grafik 152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4444" y="4867900"/>
            <a:ext cx="866068" cy="866068"/>
          </a:xfrm>
          <a:prstGeom prst="rect">
            <a:avLst/>
          </a:prstGeom>
        </p:spPr>
      </p:pic>
      <p:cxnSp>
        <p:nvCxnSpPr>
          <p:cNvPr id="154" name="Gerade Verbindung mit Pfeil 153"/>
          <p:cNvCxnSpPr>
            <a:stCxn id="181" idx="1"/>
          </p:cNvCxnSpPr>
          <p:nvPr/>
        </p:nvCxnSpPr>
        <p:spPr>
          <a:xfrm flipH="1" flipV="1">
            <a:off x="3342342" y="5243528"/>
            <a:ext cx="2074738" cy="489754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2" name="Grafik 16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746093" y="8019054"/>
            <a:ext cx="781535" cy="781535"/>
          </a:xfrm>
          <a:prstGeom prst="rect">
            <a:avLst/>
          </a:prstGeom>
        </p:spPr>
      </p:pic>
      <p:sp>
        <p:nvSpPr>
          <p:cNvPr id="166" name="Textfeld 165"/>
          <p:cNvSpPr txBox="1"/>
          <p:nvPr/>
        </p:nvSpPr>
        <p:spPr>
          <a:xfrm>
            <a:off x="1626674" y="8119518"/>
            <a:ext cx="1561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400" noProof="1">
                <a:solidFill>
                  <a:srgbClr val="020044"/>
                </a:solidFill>
              </a:rPr>
              <a:t>There are very good treatments for </a:t>
            </a:r>
            <a:r>
              <a:rPr lang="de-DE" sz="400" noProof="1" smtClean="0">
                <a:solidFill>
                  <a:srgbClr val="020044"/>
                </a:solidFill>
              </a:rPr>
              <a:t>depression</a:t>
            </a:r>
            <a:r>
              <a:rPr lang="en-GB" sz="400" dirty="0" smtClean="0">
                <a:solidFill>
                  <a:srgbClr val="000043"/>
                </a:solidFill>
              </a:rPr>
              <a:t> – especially when it occurs for the first time. </a:t>
            </a:r>
            <a:r>
              <a:rPr lang="en-GB" sz="400" b="1" dirty="0" smtClean="0">
                <a:solidFill>
                  <a:srgbClr val="52C4B1"/>
                </a:solidFill>
              </a:rPr>
              <a:t>Psychotherapy</a:t>
            </a:r>
            <a:r>
              <a:rPr lang="en-GB" sz="400" dirty="0" smtClean="0">
                <a:solidFill>
                  <a:srgbClr val="000043"/>
                </a:solidFill>
              </a:rPr>
              <a:t> or medication are most effective. </a:t>
            </a:r>
            <a:r>
              <a:rPr lang="en-GB" sz="400" b="1" dirty="0" smtClean="0">
                <a:solidFill>
                  <a:srgbClr val="52C4B1"/>
                </a:solidFill>
              </a:rPr>
              <a:t>Online therapies </a:t>
            </a:r>
            <a:r>
              <a:rPr lang="en-GB" sz="400" dirty="0" smtClean="0">
                <a:solidFill>
                  <a:srgbClr val="000043"/>
                </a:solidFill>
              </a:rPr>
              <a:t>are also readily available. Together with your health professional you can decide which treatment is best for you.</a:t>
            </a:r>
            <a:endParaRPr lang="en-GB" sz="400" dirty="0">
              <a:solidFill>
                <a:srgbClr val="000043"/>
              </a:solidFill>
            </a:endParaRPr>
          </a:p>
        </p:txBody>
      </p:sp>
      <p:sp>
        <p:nvSpPr>
          <p:cNvPr id="170" name="Textfeld 169"/>
          <p:cNvSpPr txBox="1"/>
          <p:nvPr/>
        </p:nvSpPr>
        <p:spPr>
          <a:xfrm>
            <a:off x="1625185" y="8506701"/>
            <a:ext cx="1725522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Exercise, sleep, and relaxation techniques can also help to support the therapy - </a:t>
            </a:r>
            <a:r>
              <a:rPr lang="de-DE" sz="400" b="1" noProof="1" smtClean="0">
                <a:solidFill>
                  <a:srgbClr val="4FC3B0"/>
                </a:solidFill>
              </a:rPr>
              <a:t>health courses </a:t>
            </a:r>
            <a:r>
              <a:rPr lang="de-DE" sz="400" noProof="1">
                <a:solidFill>
                  <a:srgbClr val="020044"/>
                </a:solidFill>
              </a:rPr>
              <a:t>in this field are supported by </a:t>
            </a:r>
            <a:r>
              <a:rPr lang="de-DE" sz="400" b="1" noProof="1">
                <a:solidFill>
                  <a:srgbClr val="52C4B1"/>
                </a:solidFill>
              </a:rPr>
              <a:t>your </a:t>
            </a:r>
            <a:r>
              <a:rPr lang="de-DE" sz="400" b="1" noProof="1" smtClean="0">
                <a:solidFill>
                  <a:srgbClr val="52C4B1"/>
                </a:solidFill>
              </a:rPr>
              <a:t>ABC (health insurance provder).</a:t>
            </a:r>
            <a:endParaRPr lang="de-DE" sz="400" b="1" noProof="1">
              <a:solidFill>
                <a:srgbClr val="52C4B1"/>
              </a:solidFill>
            </a:endParaRPr>
          </a:p>
        </p:txBody>
      </p:sp>
      <p:cxnSp>
        <p:nvCxnSpPr>
          <p:cNvPr id="171" name="Gerader Verbinder 170"/>
          <p:cNvCxnSpPr/>
          <p:nvPr/>
        </p:nvCxnSpPr>
        <p:spPr>
          <a:xfrm>
            <a:off x="2828171" y="8678704"/>
            <a:ext cx="360000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Gerade Verbindung mit Pfeil 171"/>
          <p:cNvCxnSpPr>
            <a:stCxn id="174" idx="1"/>
          </p:cNvCxnSpPr>
          <p:nvPr/>
        </p:nvCxnSpPr>
        <p:spPr>
          <a:xfrm flipH="1">
            <a:off x="3286626" y="8569757"/>
            <a:ext cx="2130454" cy="74469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feld 173"/>
          <p:cNvSpPr txBox="1"/>
          <p:nvPr/>
        </p:nvSpPr>
        <p:spPr>
          <a:xfrm>
            <a:off x="5417080" y="8338924"/>
            <a:ext cx="1443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health insurance </a:t>
            </a:r>
            <a:r>
              <a:rPr lang="en-US" sz="1200" dirty="0" smtClean="0"/>
              <a:t>provider</a:t>
            </a:r>
            <a:endParaRPr lang="en-US" sz="1200" dirty="0"/>
          </a:p>
        </p:txBody>
      </p:sp>
      <p:cxnSp>
        <p:nvCxnSpPr>
          <p:cNvPr id="176" name="Gerader Verbinder 175"/>
          <p:cNvCxnSpPr/>
          <p:nvPr/>
        </p:nvCxnSpPr>
        <p:spPr>
          <a:xfrm>
            <a:off x="1707542" y="8744986"/>
            <a:ext cx="402984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8" name="Textfeld 177"/>
          <p:cNvSpPr txBox="1"/>
          <p:nvPr/>
        </p:nvSpPr>
        <p:spPr>
          <a:xfrm>
            <a:off x="5417080" y="3378911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ymptom profiles </a:t>
            </a:r>
          </a:p>
        </p:txBody>
      </p:sp>
      <p:sp>
        <p:nvSpPr>
          <p:cNvPr id="179" name="Textfeld 178"/>
          <p:cNvSpPr txBox="1"/>
          <p:nvPr/>
        </p:nvSpPr>
        <p:spPr>
          <a:xfrm>
            <a:off x="5417080" y="4733931"/>
            <a:ext cx="15531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</a:t>
            </a:r>
            <a:r>
              <a:rPr lang="en-US" sz="1200" dirty="0"/>
              <a:t>causal attributions </a:t>
            </a:r>
          </a:p>
        </p:txBody>
      </p:sp>
      <p:sp>
        <p:nvSpPr>
          <p:cNvPr id="180" name="Textfeld 179"/>
          <p:cNvSpPr txBox="1"/>
          <p:nvPr/>
        </p:nvSpPr>
        <p:spPr>
          <a:xfrm>
            <a:off x="5417080" y="3899758"/>
            <a:ext cx="18022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</a:t>
            </a:r>
            <a:r>
              <a:rPr lang="en-US" sz="1200" dirty="0" smtClean="0"/>
              <a:t>nformation on depression prevalence tailored to participant’s risk profile </a:t>
            </a:r>
            <a:endParaRPr lang="en-US" sz="1200" dirty="0"/>
          </a:p>
        </p:txBody>
      </p:sp>
      <p:sp>
        <p:nvSpPr>
          <p:cNvPr id="181" name="Textfeld 180"/>
          <p:cNvSpPr txBox="1"/>
          <p:nvPr/>
        </p:nvSpPr>
        <p:spPr>
          <a:xfrm>
            <a:off x="5417080" y="5410116"/>
            <a:ext cx="1382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pecialist preferences</a:t>
            </a:r>
          </a:p>
        </p:txBody>
      </p:sp>
      <p:cxnSp>
        <p:nvCxnSpPr>
          <p:cNvPr id="182" name="Gerade Verbindung mit Pfeil 181"/>
          <p:cNvCxnSpPr/>
          <p:nvPr/>
        </p:nvCxnSpPr>
        <p:spPr>
          <a:xfrm flipH="1">
            <a:off x="4627256" y="1726918"/>
            <a:ext cx="789824" cy="26607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0147441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404411"/>
            <a:ext cx="4428000" cy="2701832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3496043"/>
            <a:ext cx="4428000" cy="2701832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0786" y="6590722"/>
            <a:ext cx="4428000" cy="2701832"/>
          </a:xfrm>
          <a:prstGeom prst="rect">
            <a:avLst/>
          </a:prstGeom>
        </p:spPr>
      </p:pic>
      <p:sp>
        <p:nvSpPr>
          <p:cNvPr id="165" name="Textfeld 164"/>
          <p:cNvSpPr txBox="1"/>
          <p:nvPr/>
        </p:nvSpPr>
        <p:spPr>
          <a:xfrm>
            <a:off x="1432696" y="7954020"/>
            <a:ext cx="191261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         Depression – how to treat i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 rotWithShape="1">
          <a:blip r:embed="rId3"/>
          <a:srcRect b="91310"/>
          <a:stretch/>
        </p:blipFill>
        <p:spPr>
          <a:xfrm>
            <a:off x="1432696" y="697334"/>
            <a:ext cx="3324179" cy="196209"/>
          </a:xfrm>
          <a:prstGeom prst="rect">
            <a:avLst/>
          </a:prstGeom>
        </p:spPr>
      </p:pic>
      <p:sp>
        <p:nvSpPr>
          <p:cNvPr id="9" name="Rechteck 8"/>
          <p:cNvSpPr/>
          <p:nvPr/>
        </p:nvSpPr>
        <p:spPr>
          <a:xfrm>
            <a:off x="1673757" y="979681"/>
            <a:ext cx="2842056" cy="856030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 sz="3829" noProof="1"/>
          </a:p>
        </p:txBody>
      </p:sp>
      <p:pic>
        <p:nvPicPr>
          <p:cNvPr id="10" name="Grafik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34237" y="1298698"/>
            <a:ext cx="1921095" cy="217995"/>
          </a:xfrm>
          <a:prstGeom prst="rect">
            <a:avLst/>
          </a:prstGeom>
        </p:spPr>
      </p:pic>
      <p:sp>
        <p:nvSpPr>
          <p:cNvPr id="11" name="Rechteck 10"/>
          <p:cNvSpPr/>
          <p:nvPr/>
        </p:nvSpPr>
        <p:spPr>
          <a:xfrm>
            <a:off x="1972685" y="1180841"/>
            <a:ext cx="2172426" cy="65401"/>
          </a:xfrm>
          <a:prstGeom prst="rect">
            <a:avLst/>
          </a:prstGeom>
          <a:solidFill>
            <a:srgbClr val="EDFBF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900" b="1" noProof="1" smtClean="0">
                <a:solidFill>
                  <a:srgbClr val="020044"/>
                </a:solidFill>
                <a:latin typeface="Constantia" panose="02030602050306030303" pitchFamily="18" charset="0"/>
              </a:rPr>
              <a:t>What did your answers reveal? </a:t>
            </a:r>
          </a:p>
          <a:p>
            <a:endParaRPr lang="de-DE" sz="1914" b="1" noProof="1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12" name="Rechteck 11"/>
          <p:cNvSpPr/>
          <p:nvPr/>
        </p:nvSpPr>
        <p:spPr>
          <a:xfrm>
            <a:off x="1972685" y="1026383"/>
            <a:ext cx="2603157" cy="37374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You have indicated that you have felt affected by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low spirits</a:t>
            </a:r>
            <a:r>
              <a:rPr lang="de-DE" sz="400" noProof="1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, 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sleep disturbances, </a:t>
            </a:r>
            <a:r>
              <a:rPr lang="de-DE" sz="400" noProof="1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and</a:t>
            </a:r>
            <a:r>
              <a:rPr lang="de-DE" sz="400" b="1" noProof="1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 loss of energy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during the past two weeks. According to our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evaluation* 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  <a:cs typeface="Times New Roman" panose="02020603050405020304" pitchFamily="18" charset="0"/>
              </a:rPr>
              <a:t>these are  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  <a:cs typeface="Times New Roman" panose="02020603050405020304" pitchFamily="18" charset="0"/>
            </a:endParaRPr>
          </a:p>
        </p:txBody>
      </p:sp>
      <p:sp>
        <p:nvSpPr>
          <p:cNvPr id="13" name="Textfeld 12"/>
          <p:cNvSpPr txBox="1"/>
          <p:nvPr/>
        </p:nvSpPr>
        <p:spPr>
          <a:xfrm>
            <a:off x="2134237" y="1298156"/>
            <a:ext cx="6044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no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4" name="Textfeld 13"/>
          <p:cNvSpPr txBox="1"/>
          <p:nvPr/>
        </p:nvSpPr>
        <p:spPr>
          <a:xfrm>
            <a:off x="2681972" y="1301249"/>
            <a:ext cx="75385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moderate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5" name="Textfeld 14"/>
          <p:cNvSpPr txBox="1"/>
          <p:nvPr/>
        </p:nvSpPr>
        <p:spPr>
          <a:xfrm>
            <a:off x="3435823" y="1301249"/>
            <a:ext cx="67457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400" b="1" noProof="1" smtClean="0">
                <a:solidFill>
                  <a:srgbClr val="020044"/>
                </a:solidFill>
              </a:rPr>
              <a:t>    significant  depressive symptoms</a:t>
            </a:r>
            <a:endParaRPr lang="de-DE" sz="400" b="1" noProof="1">
              <a:solidFill>
                <a:srgbClr val="020044"/>
              </a:solidFill>
            </a:endParaRPr>
          </a:p>
        </p:txBody>
      </p:sp>
      <p:sp>
        <p:nvSpPr>
          <p:cNvPr id="17" name="Textfeld 16"/>
          <p:cNvSpPr txBox="1"/>
          <p:nvPr/>
        </p:nvSpPr>
        <p:spPr>
          <a:xfrm>
            <a:off x="1972685" y="1516151"/>
            <a:ext cx="2082647" cy="215444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These symptoms are most likely indications of </a:t>
            </a:r>
            <a:r>
              <a:rPr lang="de-DE" sz="400" b="1" noProof="1" smtClean="0">
                <a:solidFill>
                  <a:srgbClr val="4FC3B0"/>
                </a:solidFill>
                <a:ea typeface="Inter" panose="020B0502030000000004" pitchFamily="34" charset="0"/>
              </a:rPr>
              <a:t>depression</a:t>
            </a:r>
            <a:r>
              <a:rPr lang="de-DE" sz="400" noProof="1" smtClean="0">
                <a:solidFill>
                  <a:srgbClr val="020044"/>
                </a:solidFill>
                <a:ea typeface="Inter" panose="020B0502030000000004" pitchFamily="34" charset="0"/>
              </a:rPr>
              <a:t>. Please note that this feedback does not take the place of a thorough medical diagnosis.</a:t>
            </a:r>
            <a:endParaRPr lang="de-DE" sz="400" noProof="1">
              <a:solidFill>
                <a:srgbClr val="020044"/>
              </a:solidFill>
              <a:ea typeface="Inter" panose="020B0502030000000004" pitchFamily="34" charset="0"/>
            </a:endParaRPr>
          </a:p>
        </p:txBody>
      </p:sp>
      <p:sp>
        <p:nvSpPr>
          <p:cNvPr id="18" name="Rechteck 17"/>
          <p:cNvSpPr/>
          <p:nvPr/>
        </p:nvSpPr>
        <p:spPr>
          <a:xfrm>
            <a:off x="1972685" y="1703455"/>
            <a:ext cx="681597" cy="1384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300" noProof="1" smtClean="0">
                <a:solidFill>
                  <a:srgbClr val="020044"/>
                </a:solidFill>
              </a:rPr>
              <a:t>*The evaluation is based on the</a:t>
            </a:r>
            <a:endParaRPr lang="de-DE" sz="300" noProof="1">
              <a:solidFill>
                <a:srgbClr val="020044"/>
              </a:solidFill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 rotWithShape="1">
          <a:blip r:embed="rId5"/>
          <a:srcRect l="815" t="-1" b="3317"/>
          <a:stretch/>
        </p:blipFill>
        <p:spPr>
          <a:xfrm>
            <a:off x="2557436" y="1734389"/>
            <a:ext cx="434754" cy="81369"/>
          </a:xfrm>
          <a:prstGeom prst="rect">
            <a:avLst/>
          </a:prstGeom>
        </p:spPr>
      </p:pic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1389" y="1291370"/>
            <a:ext cx="594844" cy="232649"/>
          </a:xfrm>
          <a:prstGeom prst="rect">
            <a:avLst/>
          </a:prstGeom>
        </p:spPr>
      </p:pic>
      <p:sp>
        <p:nvSpPr>
          <p:cNvPr id="2" name="Rechteck 1"/>
          <p:cNvSpPr/>
          <p:nvPr/>
        </p:nvSpPr>
        <p:spPr>
          <a:xfrm>
            <a:off x="789539" y="9618896"/>
            <a:ext cx="6468016" cy="7386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R="611505" algn="just">
              <a:spcAft>
                <a:spcPts val="1200"/>
              </a:spcAft>
            </a:pPr>
            <a:r>
              <a:rPr lang="en-US" sz="1400" noProof="1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Supplemental B. Exemplary </a:t>
            </a:r>
            <a:r>
              <a:rPr lang="en-US" sz="1400" noProof="1" smtClean="0">
                <a:solidFill>
                  <a:srgbClr val="323232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tailored feedback for participants who indicate that their symptoms are not indications of depression and that they do not worry about them (English translation)</a:t>
            </a:r>
            <a:r>
              <a:rPr lang="en-US" sz="1400" noProof="1" smtClean="0">
                <a:solidFill>
                  <a:srgbClr val="333333"/>
                </a:solidFill>
                <a:latin typeface="+mj-lt"/>
                <a:ea typeface="Times New Roman" panose="02020603050405020304" pitchFamily="18" charset="0"/>
                <a:cs typeface="Arial" panose="020B0604020202020204" pitchFamily="34" charset="0"/>
              </a:rPr>
              <a:t>. </a:t>
            </a:r>
            <a:endParaRPr lang="en-US" sz="1400" noProof="1">
              <a:solidFill>
                <a:srgbClr val="333333"/>
              </a:solidFill>
              <a:latin typeface="+mj-lt"/>
              <a:ea typeface="Times New Roman" panose="02020603050405020304" pitchFamily="18" charset="0"/>
              <a:cs typeface="Arial" panose="020B0604020202020204" pitchFamily="34" charset="0"/>
            </a:endParaRPr>
          </a:p>
        </p:txBody>
      </p:sp>
      <p:pic>
        <p:nvPicPr>
          <p:cNvPr id="105" name="Grafik 104"/>
          <p:cNvPicPr>
            <a:picLocks noChangeAspect="1"/>
          </p:cNvPicPr>
          <p:nvPr/>
        </p:nvPicPr>
        <p:blipFill rotWithShape="1">
          <a:blip r:embed="rId7"/>
          <a:srcRect b="54466"/>
          <a:stretch/>
        </p:blipFill>
        <p:spPr>
          <a:xfrm>
            <a:off x="1467647" y="6943742"/>
            <a:ext cx="3231029" cy="877751"/>
          </a:xfrm>
          <a:prstGeom prst="rect">
            <a:avLst/>
          </a:prstGeom>
        </p:spPr>
      </p:pic>
      <p:pic>
        <p:nvPicPr>
          <p:cNvPr id="99" name="Grafik 98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2055453" y="7089503"/>
            <a:ext cx="2217432" cy="203844"/>
          </a:xfrm>
          <a:prstGeom prst="rect">
            <a:avLst/>
          </a:prstGeom>
        </p:spPr>
      </p:pic>
      <p:pic>
        <p:nvPicPr>
          <p:cNvPr id="100" name="Grafik 99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856390" y="7529305"/>
            <a:ext cx="542472" cy="109812"/>
          </a:xfrm>
          <a:prstGeom prst="rect">
            <a:avLst/>
          </a:prstGeom>
        </p:spPr>
      </p:pic>
      <p:pic>
        <p:nvPicPr>
          <p:cNvPr id="101" name="Grafik 100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534305" y="7631529"/>
            <a:ext cx="589398" cy="112053"/>
          </a:xfrm>
          <a:prstGeom prst="rect">
            <a:avLst/>
          </a:prstGeom>
        </p:spPr>
      </p:pic>
      <p:pic>
        <p:nvPicPr>
          <p:cNvPr id="102" name="Grafik 101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3222390" y="7631529"/>
            <a:ext cx="486260" cy="105252"/>
          </a:xfrm>
          <a:prstGeom prst="rect">
            <a:avLst/>
          </a:prstGeom>
        </p:spPr>
      </p:pic>
      <p:pic>
        <p:nvPicPr>
          <p:cNvPr id="103" name="Grafik 10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821350" y="7529305"/>
            <a:ext cx="533021" cy="162283"/>
          </a:xfrm>
          <a:prstGeom prst="rect">
            <a:avLst/>
          </a:prstGeom>
        </p:spPr>
      </p:pic>
      <p:pic>
        <p:nvPicPr>
          <p:cNvPr id="110" name="Grafik 10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132202" y="7399310"/>
            <a:ext cx="556437" cy="556437"/>
          </a:xfrm>
          <a:prstGeom prst="rect">
            <a:avLst/>
          </a:prstGeom>
          <a:solidFill>
            <a:schemeClr val="bg1"/>
          </a:solidFill>
        </p:spPr>
      </p:pic>
      <p:pic>
        <p:nvPicPr>
          <p:cNvPr id="112" name="Grafik 111"/>
          <p:cNvPicPr>
            <a:picLocks noChangeAspect="1"/>
          </p:cNvPicPr>
          <p:nvPr/>
        </p:nvPicPr>
        <p:blipFill rotWithShape="1">
          <a:blip r:embed="rId14"/>
          <a:srcRect t="1" b="11580"/>
          <a:stretch/>
        </p:blipFill>
        <p:spPr>
          <a:xfrm>
            <a:off x="2443131" y="6941228"/>
            <a:ext cx="1282543" cy="105645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sp>
        <p:nvSpPr>
          <p:cNvPr id="113" name="Textfeld 112"/>
          <p:cNvSpPr txBox="1"/>
          <p:nvPr/>
        </p:nvSpPr>
        <p:spPr>
          <a:xfrm>
            <a:off x="2442499" y="6959733"/>
            <a:ext cx="1201127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500" b="1" noProof="1" smtClean="0">
                <a:solidFill>
                  <a:srgbClr val="000043"/>
                </a:solidFill>
                <a:latin typeface="Constantia" panose="02030602050306030303" pitchFamily="18" charset="0"/>
              </a:rPr>
              <a:t>How do I find an online therapy?</a:t>
            </a:r>
            <a:endParaRPr lang="de-DE" sz="500" b="1" noProof="1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14" name="Textfeld 113"/>
          <p:cNvSpPr txBox="1"/>
          <p:nvPr/>
        </p:nvSpPr>
        <p:spPr>
          <a:xfrm>
            <a:off x="2442499" y="7080141"/>
            <a:ext cx="1266151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With a prescription from a doctor, the following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 </a:t>
            </a:r>
            <a:r>
              <a:rPr lang="de-DE" sz="400" noProof="1" smtClean="0">
                <a:solidFill>
                  <a:srgbClr val="000043"/>
                </a:solidFill>
              </a:rPr>
              <a:t>are fully covered by your public health insurance company </a:t>
            </a:r>
            <a:r>
              <a:rPr lang="de-DE" sz="400" b="1" noProof="1" smtClean="0">
                <a:solidFill>
                  <a:srgbClr val="40C5B1"/>
                </a:solidFill>
              </a:rPr>
              <a:t>ABC</a:t>
            </a:r>
            <a:r>
              <a:rPr lang="de-DE" sz="400" noProof="1" smtClean="0">
                <a:solidFill>
                  <a:srgbClr val="000043"/>
                </a:solidFill>
              </a:rPr>
              <a:t>:</a:t>
            </a:r>
            <a:endParaRPr lang="de-DE" sz="400" noProof="1">
              <a:solidFill>
                <a:srgbClr val="000043"/>
              </a:solidFill>
            </a:endParaRPr>
          </a:p>
        </p:txBody>
      </p:sp>
      <p:sp>
        <p:nvSpPr>
          <p:cNvPr id="118" name="Textfeld 117"/>
          <p:cNvSpPr txBox="1"/>
          <p:nvPr/>
        </p:nvSpPr>
        <p:spPr>
          <a:xfrm>
            <a:off x="2594399" y="7430634"/>
            <a:ext cx="1007372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Deprexis online therapy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5" name="Textfeld 114"/>
          <p:cNvSpPr txBox="1"/>
          <p:nvPr/>
        </p:nvSpPr>
        <p:spPr>
          <a:xfrm>
            <a:off x="2593637" y="7332905"/>
            <a:ext cx="872679" cy="153888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r>
              <a:rPr lang="de-DE" sz="400" b="1" u="sng" noProof="1" smtClean="0">
                <a:solidFill>
                  <a:srgbClr val="000043"/>
                </a:solidFill>
              </a:rPr>
              <a:t>Selfapy-Course fo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6" name="Textfeld 115"/>
          <p:cNvSpPr txBox="1"/>
          <p:nvPr/>
        </p:nvSpPr>
        <p:spPr>
          <a:xfrm>
            <a:off x="2576208" y="7712670"/>
            <a:ext cx="872679" cy="276999"/>
          </a:xfrm>
          <a:prstGeom prst="rect">
            <a:avLst/>
          </a:prstGeom>
          <a:solidFill>
            <a:schemeClr val="bg1"/>
          </a:solidFill>
        </p:spPr>
        <p:txBody>
          <a:bodyPr wrap="square" lIns="36000" rtlCol="0">
            <a:spAutoFit/>
          </a:bodyPr>
          <a:lstStyle/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MindDoc (Schön-Klinik)</a:t>
            </a:r>
          </a:p>
          <a:p>
            <a:pPr>
              <a:lnSpc>
                <a:spcPct val="150000"/>
              </a:lnSpc>
            </a:pPr>
            <a:r>
              <a:rPr lang="de-DE" sz="400" b="1" u="sng" noProof="1" smtClean="0">
                <a:solidFill>
                  <a:srgbClr val="000043"/>
                </a:solidFill>
              </a:rPr>
              <a:t>HelloBetter Depression</a:t>
            </a:r>
            <a:endParaRPr lang="de-DE" sz="400" b="1" u="sng" noProof="1">
              <a:solidFill>
                <a:srgbClr val="000043"/>
              </a:solidFill>
            </a:endParaRPr>
          </a:p>
        </p:txBody>
      </p:sp>
      <p:sp>
        <p:nvSpPr>
          <p:cNvPr id="117" name="Textfeld 116"/>
          <p:cNvSpPr txBox="1"/>
          <p:nvPr/>
        </p:nvSpPr>
        <p:spPr>
          <a:xfrm>
            <a:off x="2461793" y="7538021"/>
            <a:ext cx="1226846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00043"/>
                </a:solidFill>
              </a:rPr>
              <a:t>Some health insurance companies also cover the cost of other </a:t>
            </a:r>
            <a:r>
              <a:rPr lang="de-DE" sz="400" b="1" noProof="1" smtClean="0">
                <a:solidFill>
                  <a:srgbClr val="40C5B1"/>
                </a:solidFill>
              </a:rPr>
              <a:t>online therapies</a:t>
            </a:r>
            <a:r>
              <a:rPr lang="de-DE" sz="400" noProof="1" smtClean="0">
                <a:solidFill>
                  <a:srgbClr val="000043"/>
                </a:solidFill>
              </a:rPr>
              <a:t>, such as:</a:t>
            </a:r>
            <a:endParaRPr lang="de-DE" sz="400" noProof="1">
              <a:solidFill>
                <a:srgbClr val="000043"/>
              </a:solidFill>
            </a:endParaRPr>
          </a:p>
        </p:txBody>
      </p:sp>
      <p:pic>
        <p:nvPicPr>
          <p:cNvPr id="119" name="Grafik 118"/>
          <p:cNvPicPr>
            <a:picLocks noChangeAspect="1"/>
          </p:cNvPicPr>
          <p:nvPr/>
        </p:nvPicPr>
        <p:blipFill rotWithShape="1">
          <a:blip r:embed="rId15"/>
          <a:srcRect b="15014"/>
          <a:stretch/>
        </p:blipFill>
        <p:spPr>
          <a:xfrm>
            <a:off x="2480802" y="7466833"/>
            <a:ext cx="112221" cy="84283"/>
          </a:xfrm>
          <a:prstGeom prst="rect">
            <a:avLst/>
          </a:prstGeom>
        </p:spPr>
      </p:pic>
      <p:cxnSp>
        <p:nvCxnSpPr>
          <p:cNvPr id="131" name="Gerade Verbindung mit Pfeil 130"/>
          <p:cNvCxnSpPr>
            <a:stCxn id="132" idx="1"/>
          </p:cNvCxnSpPr>
          <p:nvPr/>
        </p:nvCxnSpPr>
        <p:spPr>
          <a:xfrm flipH="1">
            <a:off x="3907412" y="965890"/>
            <a:ext cx="1509668" cy="17195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2" name="Textfeld 131"/>
          <p:cNvSpPr txBox="1"/>
          <p:nvPr/>
        </p:nvSpPr>
        <p:spPr>
          <a:xfrm>
            <a:off x="5417080" y="735057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profile</a:t>
            </a:r>
            <a:endParaRPr lang="en-US" sz="1200" dirty="0"/>
          </a:p>
        </p:txBody>
      </p:sp>
      <p:sp>
        <p:nvSpPr>
          <p:cNvPr id="155" name="Textfeld 154"/>
          <p:cNvSpPr txBox="1"/>
          <p:nvPr/>
        </p:nvSpPr>
        <p:spPr>
          <a:xfrm>
            <a:off x="5417080" y="1493612"/>
            <a:ext cx="130061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questions</a:t>
            </a:r>
            <a:r>
              <a:rPr lang="en-US" dirty="0" smtClean="0"/>
              <a:t> </a:t>
            </a:r>
            <a:endParaRPr lang="en-US" dirty="0"/>
          </a:p>
        </p:txBody>
      </p:sp>
      <p:cxnSp>
        <p:nvCxnSpPr>
          <p:cNvPr id="164" name="Gerade Verbindung mit Pfeil 163"/>
          <p:cNvCxnSpPr/>
          <p:nvPr/>
        </p:nvCxnSpPr>
        <p:spPr>
          <a:xfrm flipH="1">
            <a:off x="3690379" y="7171225"/>
            <a:ext cx="1684061" cy="295504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feld 166"/>
          <p:cNvSpPr txBox="1"/>
          <p:nvPr/>
        </p:nvSpPr>
        <p:spPr>
          <a:xfrm>
            <a:off x="5417080" y="6810267"/>
            <a:ext cx="1632935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online therapies offered by participant’s health insurance provider</a:t>
            </a:r>
            <a:endParaRPr lang="en-US" sz="1200" dirty="0"/>
          </a:p>
        </p:txBody>
      </p:sp>
      <p:cxnSp>
        <p:nvCxnSpPr>
          <p:cNvPr id="91" name="Gerader Verbinder 90"/>
          <p:cNvCxnSpPr/>
          <p:nvPr/>
        </p:nvCxnSpPr>
        <p:spPr>
          <a:xfrm>
            <a:off x="3082279" y="1208372"/>
            <a:ext cx="1044008" cy="4701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4" name="Abgerundetes Rechteck 93"/>
          <p:cNvSpPr/>
          <p:nvPr/>
        </p:nvSpPr>
        <p:spPr>
          <a:xfrm>
            <a:off x="2461435" y="7338201"/>
            <a:ext cx="1070599" cy="243118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95" name="Textfeld 94"/>
          <p:cNvSpPr txBox="1"/>
          <p:nvPr/>
        </p:nvSpPr>
        <p:spPr>
          <a:xfrm>
            <a:off x="1652262" y="3872640"/>
            <a:ext cx="171579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Depression – or something else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96" name="Textfeld 95"/>
          <p:cNvSpPr txBox="1"/>
          <p:nvPr/>
        </p:nvSpPr>
        <p:spPr>
          <a:xfrm>
            <a:off x="1652262" y="4051623"/>
            <a:ext cx="1840003" cy="73866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400" dirty="0">
                <a:solidFill>
                  <a:srgbClr val="020044"/>
                </a:solidFill>
              </a:rPr>
              <a:t>Depressive symptoms are often difficult to recognise. Get your own picture:</a:t>
            </a:r>
          </a:p>
          <a:p>
            <a:endParaRPr lang="en-GB" sz="200" dirty="0" smtClean="0">
              <a:solidFill>
                <a:srgbClr val="020044"/>
              </a:solidFill>
            </a:endParaRP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typical symptoms are for example </a:t>
            </a:r>
            <a:r>
              <a:rPr lang="en-GB" sz="400" b="1" dirty="0">
                <a:solidFill>
                  <a:srgbClr val="4FC3B0"/>
                </a:solidFill>
              </a:rPr>
              <a:t>low spirits </a:t>
            </a:r>
            <a:r>
              <a:rPr lang="en-GB" sz="400" dirty="0">
                <a:solidFill>
                  <a:srgbClr val="020044"/>
                </a:solidFill>
              </a:rPr>
              <a:t>and </a:t>
            </a:r>
            <a:r>
              <a:rPr lang="en-GB" sz="400" b="1" dirty="0">
                <a:solidFill>
                  <a:srgbClr val="4FC3B0"/>
                </a:solidFill>
              </a:rPr>
              <a:t>sleep disturbances</a:t>
            </a:r>
            <a:endParaRPr lang="en-GB" sz="400" dirty="0">
              <a:solidFill>
                <a:srgbClr val="020044"/>
              </a:solidFill>
            </a:endParaRP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depression is very common and </a:t>
            </a:r>
            <a:r>
              <a:rPr lang="en-GB" sz="400" b="1" dirty="0">
                <a:solidFill>
                  <a:srgbClr val="4FC3B0"/>
                </a:solidFill>
              </a:rPr>
              <a:t>women</a:t>
            </a:r>
            <a:r>
              <a:rPr lang="en-GB" sz="400" dirty="0">
                <a:solidFill>
                  <a:srgbClr val="020044"/>
                </a:solidFill>
              </a:rPr>
              <a:t> are particularly often affected</a:t>
            </a: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triggers are for example </a:t>
            </a:r>
            <a:r>
              <a:rPr lang="en-GB" sz="400" b="1" dirty="0">
                <a:solidFill>
                  <a:srgbClr val="4FC3B0"/>
                </a:solidFill>
              </a:rPr>
              <a:t>family problems</a:t>
            </a:r>
            <a:r>
              <a:rPr lang="en-GB" sz="400" dirty="0">
                <a:solidFill>
                  <a:srgbClr val="020044"/>
                </a:solidFill>
              </a:rPr>
              <a:t>, </a:t>
            </a:r>
            <a:r>
              <a:rPr lang="en-GB" sz="400" b="1" dirty="0">
                <a:solidFill>
                  <a:srgbClr val="4FC3B0"/>
                </a:solidFill>
              </a:rPr>
              <a:t>negative thinking patterns </a:t>
            </a:r>
            <a:r>
              <a:rPr lang="en-GB" sz="400" dirty="0">
                <a:solidFill>
                  <a:srgbClr val="020044"/>
                </a:solidFill>
              </a:rPr>
              <a:t>or </a:t>
            </a:r>
            <a:r>
              <a:rPr lang="en-GB" sz="400" b="1" dirty="0">
                <a:solidFill>
                  <a:srgbClr val="4FC3B0"/>
                </a:solidFill>
              </a:rPr>
              <a:t>diabetes</a:t>
            </a:r>
            <a:endParaRPr lang="en-GB" sz="400" dirty="0">
              <a:solidFill>
                <a:srgbClr val="020044"/>
              </a:solidFill>
            </a:endParaRPr>
          </a:p>
          <a:p>
            <a:pPr marL="169863" indent="-80963">
              <a:buFont typeface="Arial" panose="020B0604020202020204" pitchFamily="34" charset="0"/>
              <a:buChar char="•"/>
            </a:pPr>
            <a:r>
              <a:rPr lang="en-GB" sz="400" dirty="0">
                <a:solidFill>
                  <a:srgbClr val="020044"/>
                </a:solidFill>
              </a:rPr>
              <a:t>symptoms can subside on their own, but without treatment they </a:t>
            </a:r>
            <a:r>
              <a:rPr lang="en-GB" sz="400" b="1" dirty="0">
                <a:solidFill>
                  <a:srgbClr val="4FC3B0"/>
                </a:solidFill>
              </a:rPr>
              <a:t>often come back </a:t>
            </a:r>
            <a:r>
              <a:rPr lang="en-GB" sz="400" b="1" dirty="0" smtClean="0">
                <a:solidFill>
                  <a:srgbClr val="4FC3B0"/>
                </a:solidFill>
              </a:rPr>
              <a:t>again</a:t>
            </a:r>
          </a:p>
          <a:p>
            <a:pPr marL="169863" indent="-80963">
              <a:buFont typeface="Arial" panose="020B0604020202020204" pitchFamily="34" charset="0"/>
              <a:buChar char="•"/>
            </a:pPr>
            <a:endParaRPr lang="en-GB" sz="300" b="1" dirty="0">
              <a:solidFill>
                <a:srgbClr val="4FC3B0"/>
              </a:solidFill>
            </a:endParaRPr>
          </a:p>
          <a:p>
            <a:r>
              <a:rPr lang="de-DE" sz="400" noProof="1" smtClean="0">
                <a:solidFill>
                  <a:srgbClr val="020044"/>
                </a:solidFill>
              </a:rPr>
              <a:t>More </a:t>
            </a:r>
            <a:r>
              <a:rPr lang="de-DE" sz="400" noProof="1">
                <a:solidFill>
                  <a:srgbClr val="020044"/>
                </a:solidFill>
              </a:rPr>
              <a:t>information can be found </a:t>
            </a:r>
            <a:r>
              <a:rPr lang="de-DE" sz="400" noProof="1" smtClean="0">
                <a:solidFill>
                  <a:srgbClr val="020044"/>
                </a:solidFill>
              </a:rPr>
              <a:t>at </a:t>
            </a:r>
            <a:endParaRPr lang="de-DE" sz="400" noProof="1">
              <a:solidFill>
                <a:srgbClr val="020044"/>
              </a:solidFill>
            </a:endParaRPr>
          </a:p>
          <a:p>
            <a:r>
              <a:rPr lang="en-GB" sz="400" b="1" dirty="0" smtClean="0">
                <a:solidFill>
                  <a:srgbClr val="4FC3B0"/>
                </a:solidFill>
              </a:rPr>
              <a:t> </a:t>
            </a:r>
            <a:endParaRPr lang="en-GB" sz="400" b="1" dirty="0">
              <a:solidFill>
                <a:srgbClr val="4FC3B0"/>
              </a:solidFill>
            </a:endParaRPr>
          </a:p>
        </p:txBody>
      </p:sp>
      <p:pic>
        <p:nvPicPr>
          <p:cNvPr id="98" name="Grafik 97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2470361" y="4561378"/>
            <a:ext cx="137160" cy="104172"/>
          </a:xfrm>
          <a:prstGeom prst="rect">
            <a:avLst/>
          </a:prstGeom>
        </p:spPr>
      </p:pic>
      <p:sp>
        <p:nvSpPr>
          <p:cNvPr id="104" name="Textfeld 103"/>
          <p:cNvSpPr txBox="1"/>
          <p:nvPr/>
        </p:nvSpPr>
        <p:spPr>
          <a:xfrm>
            <a:off x="2524674" y="4536906"/>
            <a:ext cx="601861" cy="1538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400" u="sng" noProof="1" smtClean="0">
                <a:solidFill>
                  <a:srgbClr val="292B64"/>
                </a:solidFill>
              </a:rPr>
              <a:t>www.psychenet.de</a:t>
            </a:r>
            <a:endParaRPr lang="de-DE" sz="400" u="sng" noProof="1">
              <a:solidFill>
                <a:srgbClr val="292B64"/>
              </a:solidFill>
            </a:endParaRPr>
          </a:p>
        </p:txBody>
      </p:sp>
      <p:cxnSp>
        <p:nvCxnSpPr>
          <p:cNvPr id="107" name="Gerader Verbinder 106"/>
          <p:cNvCxnSpPr/>
          <p:nvPr/>
        </p:nvCxnSpPr>
        <p:spPr>
          <a:xfrm>
            <a:off x="2407138" y="4375119"/>
            <a:ext cx="937641" cy="365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Gerader Verbinder 108"/>
          <p:cNvCxnSpPr/>
          <p:nvPr/>
        </p:nvCxnSpPr>
        <p:spPr>
          <a:xfrm>
            <a:off x="2612153" y="4243990"/>
            <a:ext cx="735105" cy="1043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0" name="Abgerundetes Rechteck 119"/>
          <p:cNvSpPr/>
          <p:nvPr/>
        </p:nvSpPr>
        <p:spPr>
          <a:xfrm>
            <a:off x="1882798" y="4255068"/>
            <a:ext cx="1532003" cy="60169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cxnSp>
        <p:nvCxnSpPr>
          <p:cNvPr id="121" name="Gerader Verbinder 120"/>
          <p:cNvCxnSpPr/>
          <p:nvPr/>
        </p:nvCxnSpPr>
        <p:spPr>
          <a:xfrm>
            <a:off x="1909833" y="4431266"/>
            <a:ext cx="195693" cy="366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2" name="Grafik 121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600559" y="3939973"/>
            <a:ext cx="781535" cy="781535"/>
          </a:xfrm>
          <a:prstGeom prst="rect">
            <a:avLst/>
          </a:prstGeom>
        </p:spPr>
      </p:pic>
      <p:cxnSp>
        <p:nvCxnSpPr>
          <p:cNvPr id="125" name="Gerade Verbindung mit Pfeil 124"/>
          <p:cNvCxnSpPr>
            <a:stCxn id="111" idx="1"/>
          </p:cNvCxnSpPr>
          <p:nvPr/>
        </p:nvCxnSpPr>
        <p:spPr>
          <a:xfrm flipH="1">
            <a:off x="3412572" y="3474698"/>
            <a:ext cx="2004508" cy="710270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6" name="Gerade Verbindung mit Pfeil 125"/>
          <p:cNvCxnSpPr>
            <a:stCxn id="123" idx="1"/>
          </p:cNvCxnSpPr>
          <p:nvPr/>
        </p:nvCxnSpPr>
        <p:spPr>
          <a:xfrm flipH="1" flipV="1">
            <a:off x="3368056" y="4400026"/>
            <a:ext cx="2049024" cy="513150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9" name="Gerade Verbindung mit Pfeil 128"/>
          <p:cNvCxnSpPr>
            <a:stCxn id="133" idx="1"/>
          </p:cNvCxnSpPr>
          <p:nvPr/>
        </p:nvCxnSpPr>
        <p:spPr>
          <a:xfrm flipH="1">
            <a:off x="3466316" y="4171334"/>
            <a:ext cx="1950764" cy="127110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0" name="Textfeld 129"/>
          <p:cNvSpPr txBox="1"/>
          <p:nvPr/>
        </p:nvSpPr>
        <p:spPr>
          <a:xfrm>
            <a:off x="2529323" y="4907073"/>
            <a:ext cx="1912614" cy="200055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700" b="1" dirty="0" smtClean="0">
                <a:solidFill>
                  <a:srgbClr val="000043"/>
                </a:solidFill>
                <a:latin typeface="Constantia" panose="02030602050306030303" pitchFamily="18" charset="0"/>
              </a:rPr>
              <a:t>         And now – what should I do first?</a:t>
            </a:r>
            <a:endParaRPr lang="en-GB" sz="700" b="1" dirty="0">
              <a:solidFill>
                <a:srgbClr val="000043"/>
              </a:solidFill>
              <a:latin typeface="Constantia" panose="02030602050306030303" pitchFamily="18" charset="0"/>
            </a:endParaRPr>
          </a:p>
        </p:txBody>
      </p:sp>
      <p:sp>
        <p:nvSpPr>
          <p:cNvPr id="135" name="Textfeld 134"/>
          <p:cNvSpPr txBox="1"/>
          <p:nvPr/>
        </p:nvSpPr>
        <p:spPr>
          <a:xfrm>
            <a:off x="2718488" y="5059111"/>
            <a:ext cx="1561931" cy="4001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GB" sz="400" dirty="0">
                <a:solidFill>
                  <a:srgbClr val="020044"/>
                </a:solidFill>
              </a:rPr>
              <a:t>Depression may have long-term consequences – for example, the risk of developing cancer or dementia is significantly increased</a:t>
            </a:r>
            <a:r>
              <a:rPr lang="en-GB" sz="400" dirty="0" smtClean="0">
                <a:solidFill>
                  <a:srgbClr val="020044"/>
                </a:solidFill>
              </a:rPr>
              <a:t>. To rule out depression</a:t>
            </a:r>
            <a:r>
              <a:rPr lang="en-GB" sz="400" dirty="0" smtClean="0">
                <a:solidFill>
                  <a:srgbClr val="000043"/>
                </a:solidFill>
              </a:rPr>
              <a:t>, you should make an </a:t>
            </a:r>
            <a:r>
              <a:rPr lang="en-GB" sz="400" b="1" dirty="0" smtClean="0">
                <a:solidFill>
                  <a:srgbClr val="52C4B1"/>
                </a:solidFill>
              </a:rPr>
              <a:t>appointment with your general practitioner </a:t>
            </a:r>
            <a:r>
              <a:rPr lang="en-GB" sz="400" dirty="0" smtClean="0">
                <a:solidFill>
                  <a:srgbClr val="000043"/>
                </a:solidFill>
              </a:rPr>
              <a:t>to talk about your evaluation. You can print it out and take it with you to start the conversation.</a:t>
            </a:r>
            <a:endParaRPr lang="en-GB" sz="400" dirty="0">
              <a:solidFill>
                <a:srgbClr val="000043"/>
              </a:solidFill>
            </a:endParaRPr>
          </a:p>
        </p:txBody>
      </p:sp>
      <p:pic>
        <p:nvPicPr>
          <p:cNvPr id="136" name="Grafik 135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2803042" y="5438567"/>
            <a:ext cx="122036" cy="113761"/>
          </a:xfrm>
          <a:prstGeom prst="rect">
            <a:avLst/>
          </a:prstGeom>
        </p:spPr>
      </p:pic>
      <p:sp>
        <p:nvSpPr>
          <p:cNvPr id="139" name="Textfeld 138"/>
          <p:cNvSpPr txBox="1"/>
          <p:nvPr/>
        </p:nvSpPr>
        <p:spPr>
          <a:xfrm>
            <a:off x="2844746" y="5435930"/>
            <a:ext cx="490333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Print your feedback </a:t>
            </a:r>
            <a:endParaRPr lang="en-GB" sz="300" u="sng" dirty="0"/>
          </a:p>
        </p:txBody>
      </p:sp>
      <p:pic>
        <p:nvPicPr>
          <p:cNvPr id="140" name="Grafik 139"/>
          <p:cNvPicPr>
            <a:picLocks noChangeAspect="1"/>
          </p:cNvPicPr>
          <p:nvPr/>
        </p:nvPicPr>
        <p:blipFill rotWithShape="1">
          <a:blip r:embed="rId15"/>
          <a:srcRect b="15014"/>
          <a:stretch/>
        </p:blipFill>
        <p:spPr>
          <a:xfrm>
            <a:off x="3245102" y="5435931"/>
            <a:ext cx="154984" cy="116399"/>
          </a:xfrm>
          <a:prstGeom prst="rect">
            <a:avLst/>
          </a:prstGeom>
        </p:spPr>
      </p:pic>
      <p:sp>
        <p:nvSpPr>
          <p:cNvPr id="149" name="Textfeld 148"/>
          <p:cNvSpPr txBox="1"/>
          <p:nvPr/>
        </p:nvSpPr>
        <p:spPr>
          <a:xfrm>
            <a:off x="3322594" y="5436447"/>
            <a:ext cx="545309" cy="1384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300" u="sng" dirty="0" smtClean="0">
                <a:solidFill>
                  <a:srgbClr val="020044"/>
                </a:solidFill>
              </a:rPr>
              <a:t>Make an appointment</a:t>
            </a:r>
            <a:endParaRPr lang="en-GB" sz="300" u="sng" dirty="0"/>
          </a:p>
        </p:txBody>
      </p:sp>
      <p:cxnSp>
        <p:nvCxnSpPr>
          <p:cNvPr id="150" name="Gerader Verbinder 149"/>
          <p:cNvCxnSpPr/>
          <p:nvPr/>
        </p:nvCxnSpPr>
        <p:spPr>
          <a:xfrm>
            <a:off x="2794000" y="5350933"/>
            <a:ext cx="428390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53" name="Grafik 152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24444" y="4867900"/>
            <a:ext cx="866068" cy="866068"/>
          </a:xfrm>
          <a:prstGeom prst="rect">
            <a:avLst/>
          </a:prstGeom>
        </p:spPr>
      </p:pic>
      <p:cxnSp>
        <p:nvCxnSpPr>
          <p:cNvPr id="154" name="Gerade Verbindung mit Pfeil 153"/>
          <p:cNvCxnSpPr>
            <a:stCxn id="137" idx="1"/>
          </p:cNvCxnSpPr>
          <p:nvPr/>
        </p:nvCxnSpPr>
        <p:spPr>
          <a:xfrm flipH="1" flipV="1">
            <a:off x="3264094" y="5345280"/>
            <a:ext cx="2172668" cy="948268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2" name="Grafik 161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3746093" y="8019054"/>
            <a:ext cx="781535" cy="781535"/>
          </a:xfrm>
          <a:prstGeom prst="rect">
            <a:avLst/>
          </a:prstGeom>
        </p:spPr>
      </p:pic>
      <p:sp>
        <p:nvSpPr>
          <p:cNvPr id="166" name="Textfeld 165"/>
          <p:cNvSpPr txBox="1"/>
          <p:nvPr/>
        </p:nvSpPr>
        <p:spPr>
          <a:xfrm>
            <a:off x="1626674" y="8119518"/>
            <a:ext cx="1561931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400" noProof="1">
                <a:solidFill>
                  <a:srgbClr val="020044"/>
                </a:solidFill>
              </a:rPr>
              <a:t>There are very good treatments for </a:t>
            </a:r>
            <a:r>
              <a:rPr lang="de-DE" sz="400" noProof="1" smtClean="0">
                <a:solidFill>
                  <a:srgbClr val="020044"/>
                </a:solidFill>
              </a:rPr>
              <a:t>depression</a:t>
            </a:r>
            <a:r>
              <a:rPr lang="en-GB" sz="400" dirty="0" smtClean="0">
                <a:solidFill>
                  <a:srgbClr val="000043"/>
                </a:solidFill>
              </a:rPr>
              <a:t> – especially when it occurs for the first time. </a:t>
            </a:r>
            <a:r>
              <a:rPr lang="en-GB" sz="400" b="1" dirty="0" smtClean="0">
                <a:solidFill>
                  <a:srgbClr val="52C4B1"/>
                </a:solidFill>
              </a:rPr>
              <a:t>Psychotherapy</a:t>
            </a:r>
            <a:r>
              <a:rPr lang="en-GB" sz="400" dirty="0" smtClean="0">
                <a:solidFill>
                  <a:srgbClr val="000043"/>
                </a:solidFill>
              </a:rPr>
              <a:t> or medication are most effective. </a:t>
            </a:r>
            <a:r>
              <a:rPr lang="en-GB" sz="400" b="1" dirty="0" smtClean="0">
                <a:solidFill>
                  <a:srgbClr val="52C4B1"/>
                </a:solidFill>
              </a:rPr>
              <a:t>Online therapies </a:t>
            </a:r>
            <a:r>
              <a:rPr lang="en-GB" sz="400" dirty="0" smtClean="0">
                <a:solidFill>
                  <a:srgbClr val="000043"/>
                </a:solidFill>
              </a:rPr>
              <a:t>are also readily available. Together with your health professional you can decide which treatment is best for you.</a:t>
            </a:r>
            <a:endParaRPr lang="en-GB" sz="400" dirty="0">
              <a:solidFill>
                <a:srgbClr val="000043"/>
              </a:solidFill>
            </a:endParaRPr>
          </a:p>
        </p:txBody>
      </p:sp>
      <p:sp>
        <p:nvSpPr>
          <p:cNvPr id="170" name="Textfeld 169"/>
          <p:cNvSpPr txBox="1"/>
          <p:nvPr/>
        </p:nvSpPr>
        <p:spPr>
          <a:xfrm>
            <a:off x="1625185" y="8506701"/>
            <a:ext cx="1725522" cy="276999"/>
          </a:xfrm>
          <a:prstGeom prst="rect">
            <a:avLst/>
          </a:prstGeom>
          <a:solidFill>
            <a:srgbClr val="FFFFFF"/>
          </a:solidFill>
        </p:spPr>
        <p:txBody>
          <a:bodyPr wrap="square" rtlCol="0">
            <a:spAutoFit/>
          </a:bodyPr>
          <a:lstStyle/>
          <a:p>
            <a:r>
              <a:rPr lang="de-DE" sz="400" noProof="1" smtClean="0">
                <a:solidFill>
                  <a:srgbClr val="020044"/>
                </a:solidFill>
              </a:rPr>
              <a:t>Exercise, sleep, and relaxation techniques can also help to support the therapy - </a:t>
            </a:r>
            <a:r>
              <a:rPr lang="de-DE" sz="400" b="1" noProof="1" smtClean="0">
                <a:solidFill>
                  <a:srgbClr val="4FC3B0"/>
                </a:solidFill>
              </a:rPr>
              <a:t>health courses </a:t>
            </a:r>
            <a:r>
              <a:rPr lang="de-DE" sz="400" noProof="1">
                <a:solidFill>
                  <a:srgbClr val="020044"/>
                </a:solidFill>
              </a:rPr>
              <a:t>in this field are supported by </a:t>
            </a:r>
            <a:r>
              <a:rPr lang="de-DE" sz="400" b="1" noProof="1">
                <a:solidFill>
                  <a:srgbClr val="52C4B1"/>
                </a:solidFill>
              </a:rPr>
              <a:t>your </a:t>
            </a:r>
            <a:r>
              <a:rPr lang="de-DE" sz="400" b="1" noProof="1" smtClean="0">
                <a:solidFill>
                  <a:srgbClr val="52C4B1"/>
                </a:solidFill>
              </a:rPr>
              <a:t>ABC (health insurance provder).</a:t>
            </a:r>
            <a:endParaRPr lang="de-DE" sz="400" b="1" noProof="1">
              <a:solidFill>
                <a:srgbClr val="52C4B1"/>
              </a:solidFill>
            </a:endParaRPr>
          </a:p>
        </p:txBody>
      </p:sp>
      <p:cxnSp>
        <p:nvCxnSpPr>
          <p:cNvPr id="171" name="Gerader Verbinder 170"/>
          <p:cNvCxnSpPr/>
          <p:nvPr/>
        </p:nvCxnSpPr>
        <p:spPr>
          <a:xfrm>
            <a:off x="2828171" y="8678704"/>
            <a:ext cx="360000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2" name="Gerade Verbindung mit Pfeil 171"/>
          <p:cNvCxnSpPr/>
          <p:nvPr/>
        </p:nvCxnSpPr>
        <p:spPr>
          <a:xfrm flipH="1">
            <a:off x="3286626" y="8591034"/>
            <a:ext cx="2130454" cy="53192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feld 173"/>
          <p:cNvSpPr txBox="1"/>
          <p:nvPr/>
        </p:nvSpPr>
        <p:spPr>
          <a:xfrm>
            <a:off x="5417080" y="8338924"/>
            <a:ext cx="144345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health insurance </a:t>
            </a:r>
            <a:r>
              <a:rPr lang="en-US" sz="1200" dirty="0" smtClean="0"/>
              <a:t>provider</a:t>
            </a:r>
            <a:endParaRPr lang="en-US" sz="1200" dirty="0"/>
          </a:p>
        </p:txBody>
      </p:sp>
      <p:cxnSp>
        <p:nvCxnSpPr>
          <p:cNvPr id="176" name="Gerader Verbinder 175"/>
          <p:cNvCxnSpPr/>
          <p:nvPr/>
        </p:nvCxnSpPr>
        <p:spPr>
          <a:xfrm>
            <a:off x="1707542" y="8744986"/>
            <a:ext cx="402984" cy="0"/>
          </a:xfrm>
          <a:prstGeom prst="line">
            <a:avLst/>
          </a:prstGeom>
          <a:ln>
            <a:solidFill>
              <a:schemeClr val="accent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4" name="Grafik 83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1702817" y="1960633"/>
            <a:ext cx="2772000" cy="386175"/>
          </a:xfrm>
          <a:prstGeom prst="rect">
            <a:avLst/>
          </a:prstGeom>
        </p:spPr>
      </p:pic>
      <p:sp>
        <p:nvSpPr>
          <p:cNvPr id="85" name="Textfeld 84"/>
          <p:cNvSpPr txBox="1"/>
          <p:nvPr/>
        </p:nvSpPr>
        <p:spPr>
          <a:xfrm>
            <a:off x="1727202" y="1975808"/>
            <a:ext cx="1355960" cy="246478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Do you think your symptoms are </a:t>
            </a:r>
            <a:r>
              <a:rPr lang="en-GB" sz="501" b="1" dirty="0">
                <a:solidFill>
                  <a:srgbClr val="020044"/>
                </a:solidFill>
                <a:latin typeface="Constantia" panose="02030602050306030303" pitchFamily="18" charset="0"/>
              </a:rPr>
              <a:t>indications </a:t>
            </a:r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of depression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86" name="Textfeld 85"/>
          <p:cNvSpPr txBox="1"/>
          <p:nvPr/>
        </p:nvSpPr>
        <p:spPr>
          <a:xfrm>
            <a:off x="3118219" y="1981179"/>
            <a:ext cx="1394813" cy="169405"/>
          </a:xfrm>
          <a:prstGeom prst="rect">
            <a:avLst/>
          </a:prstGeom>
          <a:solidFill>
            <a:srgbClr val="EDFBF9"/>
          </a:solidFill>
        </p:spPr>
        <p:txBody>
          <a:bodyPr wrap="square" rtlCol="0">
            <a:spAutoFit/>
          </a:bodyPr>
          <a:lstStyle/>
          <a:p>
            <a:r>
              <a:rPr lang="en-GB" sz="501" b="1" dirty="0" smtClean="0">
                <a:solidFill>
                  <a:srgbClr val="020044"/>
                </a:solidFill>
                <a:latin typeface="Constantia" panose="02030602050306030303" pitchFamily="18" charset="0"/>
              </a:rPr>
              <a:t>Are you worried about your symptoms?</a:t>
            </a:r>
            <a:endParaRPr lang="en-GB" sz="501" b="1" dirty="0">
              <a:solidFill>
                <a:srgbClr val="020044"/>
              </a:solidFill>
              <a:latin typeface="Constantia" panose="02030602050306030303" pitchFamily="18" charset="0"/>
            </a:endParaRPr>
          </a:p>
        </p:txBody>
      </p:sp>
      <p:sp>
        <p:nvSpPr>
          <p:cNvPr id="87" name="Textfeld 86"/>
          <p:cNvSpPr txBox="1"/>
          <p:nvPr/>
        </p:nvSpPr>
        <p:spPr>
          <a:xfrm>
            <a:off x="2011870" y="2189515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88" name="Textfeld 87"/>
          <p:cNvSpPr txBox="1"/>
          <p:nvPr/>
        </p:nvSpPr>
        <p:spPr>
          <a:xfrm>
            <a:off x="2265901" y="2189616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89" name="Textfeld 88"/>
          <p:cNvSpPr txBox="1"/>
          <p:nvPr/>
        </p:nvSpPr>
        <p:spPr>
          <a:xfrm>
            <a:off x="2522367" y="2189491"/>
            <a:ext cx="334322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maybe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90" name="Textfeld 89"/>
          <p:cNvSpPr txBox="1"/>
          <p:nvPr/>
        </p:nvSpPr>
        <p:spPr>
          <a:xfrm>
            <a:off x="3532034" y="2188419"/>
            <a:ext cx="252001" cy="100800"/>
          </a:xfrm>
          <a:prstGeom prst="rect">
            <a:avLst/>
          </a:prstGeom>
          <a:solidFill>
            <a:srgbClr val="EDFBF9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yes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93" name="Textfeld 92"/>
          <p:cNvSpPr txBox="1"/>
          <p:nvPr/>
        </p:nvSpPr>
        <p:spPr>
          <a:xfrm>
            <a:off x="3785903" y="2187136"/>
            <a:ext cx="252001" cy="100800"/>
          </a:xfrm>
          <a:prstGeom prst="rect">
            <a:avLst/>
          </a:prstGeom>
          <a:solidFill>
            <a:srgbClr val="000043"/>
          </a:solidFill>
          <a:ln>
            <a:solidFill>
              <a:srgbClr val="52C4B1"/>
            </a:solidFill>
          </a:ln>
        </p:spPr>
        <p:txBody>
          <a:bodyPr wrap="square" rtlCol="0" anchor="ctr" anchorCtr="0">
            <a:spAutoFit/>
          </a:bodyPr>
          <a:lstStyle/>
          <a:p>
            <a:r>
              <a:rPr lang="en-GB" sz="400" dirty="0" smtClean="0">
                <a:solidFill>
                  <a:srgbClr val="52C4B1"/>
                </a:solidFill>
              </a:rPr>
              <a:t>no</a:t>
            </a:r>
            <a:endParaRPr lang="en-GB" sz="400" dirty="0">
              <a:solidFill>
                <a:srgbClr val="52C4B1"/>
              </a:solidFill>
            </a:endParaRPr>
          </a:p>
        </p:txBody>
      </p:sp>
      <p:sp>
        <p:nvSpPr>
          <p:cNvPr id="97" name="Textfeld 96"/>
          <p:cNvSpPr txBox="1"/>
          <p:nvPr/>
        </p:nvSpPr>
        <p:spPr>
          <a:xfrm>
            <a:off x="4469486" y="1967487"/>
            <a:ext cx="4571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lang="en-GB" dirty="0"/>
          </a:p>
        </p:txBody>
      </p:sp>
      <p:sp>
        <p:nvSpPr>
          <p:cNvPr id="106" name="Abgerundetes Rechteck 105"/>
          <p:cNvSpPr/>
          <p:nvPr/>
        </p:nvSpPr>
        <p:spPr>
          <a:xfrm>
            <a:off x="1609611" y="1873278"/>
            <a:ext cx="2966232" cy="541682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Abgerundetes Rechteck 107"/>
          <p:cNvSpPr/>
          <p:nvPr/>
        </p:nvSpPr>
        <p:spPr>
          <a:xfrm>
            <a:off x="2794000" y="5107241"/>
            <a:ext cx="1401233" cy="123288"/>
          </a:xfrm>
          <a:prstGeom prst="roundRect">
            <a:avLst/>
          </a:prstGeom>
          <a:noFill/>
          <a:ln w="6350">
            <a:solidFill>
              <a:schemeClr val="accent4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11" name="Textfeld 110"/>
          <p:cNvSpPr txBox="1"/>
          <p:nvPr/>
        </p:nvSpPr>
        <p:spPr>
          <a:xfrm>
            <a:off x="5417080" y="3243865"/>
            <a:ext cx="155312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ymptom profiles </a:t>
            </a:r>
          </a:p>
        </p:txBody>
      </p:sp>
      <p:sp>
        <p:nvSpPr>
          <p:cNvPr id="123" name="Textfeld 122"/>
          <p:cNvSpPr txBox="1"/>
          <p:nvPr/>
        </p:nvSpPr>
        <p:spPr>
          <a:xfrm>
            <a:off x="5417080" y="4590010"/>
            <a:ext cx="155312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symptom </a:t>
            </a:r>
            <a:r>
              <a:rPr lang="en-US" sz="1200" dirty="0"/>
              <a:t>causal attributions </a:t>
            </a:r>
          </a:p>
        </p:txBody>
      </p:sp>
      <p:sp>
        <p:nvSpPr>
          <p:cNvPr id="133" name="Textfeld 132"/>
          <p:cNvSpPr txBox="1"/>
          <p:nvPr/>
        </p:nvSpPr>
        <p:spPr>
          <a:xfrm>
            <a:off x="5417080" y="3755835"/>
            <a:ext cx="180226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</a:t>
            </a:r>
            <a:r>
              <a:rPr lang="en-US" sz="1200" dirty="0" smtClean="0"/>
              <a:t>nformation on depression prevalence tailored to participant’s risk profile </a:t>
            </a:r>
            <a:endParaRPr lang="en-US" sz="1200" dirty="0"/>
          </a:p>
        </p:txBody>
      </p:sp>
      <p:sp>
        <p:nvSpPr>
          <p:cNvPr id="137" name="Textfeld 136"/>
          <p:cNvSpPr txBox="1"/>
          <p:nvPr/>
        </p:nvSpPr>
        <p:spPr>
          <a:xfrm>
            <a:off x="5436762" y="5970382"/>
            <a:ext cx="138259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participant’s </a:t>
            </a:r>
            <a:r>
              <a:rPr lang="en-US" sz="1200" dirty="0"/>
              <a:t>specialist preferences</a:t>
            </a:r>
          </a:p>
        </p:txBody>
      </p:sp>
      <p:sp>
        <p:nvSpPr>
          <p:cNvPr id="138" name="Textfeld 137"/>
          <p:cNvSpPr txBox="1"/>
          <p:nvPr/>
        </p:nvSpPr>
        <p:spPr>
          <a:xfrm>
            <a:off x="5428580" y="5279456"/>
            <a:ext cx="16547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i</a:t>
            </a:r>
            <a:r>
              <a:rPr lang="en-US" sz="1200" dirty="0" smtClean="0"/>
              <a:t>nformation on negative consequences of depression</a:t>
            </a:r>
            <a:endParaRPr lang="en-US" sz="1200" dirty="0"/>
          </a:p>
        </p:txBody>
      </p:sp>
      <p:cxnSp>
        <p:nvCxnSpPr>
          <p:cNvPr id="141" name="Gerade Verbindung mit Pfeil 140"/>
          <p:cNvCxnSpPr>
            <a:stCxn id="138" idx="1"/>
          </p:cNvCxnSpPr>
          <p:nvPr/>
        </p:nvCxnSpPr>
        <p:spPr>
          <a:xfrm flipH="1" flipV="1">
            <a:off x="4236921" y="5184713"/>
            <a:ext cx="1191659" cy="417909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2" name="Gerade Verbindung mit Pfeil 141"/>
          <p:cNvCxnSpPr/>
          <p:nvPr/>
        </p:nvCxnSpPr>
        <p:spPr>
          <a:xfrm flipH="1">
            <a:off x="4627256" y="1726918"/>
            <a:ext cx="789824" cy="266073"/>
          </a:xfrm>
          <a:prstGeom prst="straightConnector1">
            <a:avLst/>
          </a:prstGeom>
          <a:ln>
            <a:solidFill>
              <a:schemeClr val="accent4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68856134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53</Words>
  <Application>Microsoft Office PowerPoint</Application>
  <PresentationFormat>Benutzerdefiniert</PresentationFormat>
  <Paragraphs>195</Paragraphs>
  <Slides>4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Constantia</vt:lpstr>
      <vt:lpstr>Inter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</vt:vector>
  </TitlesOfParts>
  <Company>UK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Volkmann, Marieke</dc:creator>
  <cp:lastModifiedBy>Sikorski, Franziska</cp:lastModifiedBy>
  <cp:revision>43</cp:revision>
  <dcterms:created xsi:type="dcterms:W3CDTF">2021-02-25T10:52:36Z</dcterms:created>
  <dcterms:modified xsi:type="dcterms:W3CDTF">2024-04-12T18:25:41Z</dcterms:modified>
</cp:coreProperties>
</file>